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8" r:id="rId3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C866953-DF8E-3F4C-9692-3415286BBDF5}" v="2" dt="2024-11-08T16:47:07.65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523"/>
    <p:restoredTop sz="94703"/>
  </p:normalViewPr>
  <p:slideViewPr>
    <p:cSldViewPr snapToGrid="0">
      <p:cViewPr>
        <p:scale>
          <a:sx n="114" d="100"/>
          <a:sy n="114" d="100"/>
        </p:scale>
        <p:origin x="664" y="10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rance Côté" userId="491ff76e-7bd0-4aca-bb65-325f4c6ba843" providerId="ADAL" clId="{3C866953-DF8E-3F4C-9692-3415286BBDF5}"/>
    <pc:docChg chg="undo custSel delSld modSld">
      <pc:chgData name="France Côté" userId="491ff76e-7bd0-4aca-bb65-325f4c6ba843" providerId="ADAL" clId="{3C866953-DF8E-3F4C-9692-3415286BBDF5}" dt="2024-11-08T16:47:14.722" v="90" actId="1036"/>
      <pc:docMkLst>
        <pc:docMk/>
      </pc:docMkLst>
      <pc:sldChg chg="addSp delSp modSp mod">
        <pc:chgData name="France Côté" userId="491ff76e-7bd0-4aca-bb65-325f4c6ba843" providerId="ADAL" clId="{3C866953-DF8E-3F4C-9692-3415286BBDF5}" dt="2024-11-08T16:43:30.538" v="11" actId="478"/>
        <pc:sldMkLst>
          <pc:docMk/>
          <pc:sldMk cId="1019936381" sldId="256"/>
        </pc:sldMkLst>
        <pc:spChg chg="del">
          <ac:chgData name="France Côté" userId="491ff76e-7bd0-4aca-bb65-325f4c6ba843" providerId="ADAL" clId="{3C866953-DF8E-3F4C-9692-3415286BBDF5}" dt="2024-11-08T16:43:30.538" v="11" actId="478"/>
          <ac:spMkLst>
            <pc:docMk/>
            <pc:sldMk cId="1019936381" sldId="256"/>
            <ac:spMk id="2" creationId="{41A18460-8AE6-A324-6A2B-5C42549F6075}"/>
          </ac:spMkLst>
        </pc:spChg>
        <pc:spChg chg="del">
          <ac:chgData name="France Côté" userId="491ff76e-7bd0-4aca-bb65-325f4c6ba843" providerId="ADAL" clId="{3C866953-DF8E-3F4C-9692-3415286BBDF5}" dt="2024-11-08T16:42:08.543" v="2" actId="478"/>
          <ac:spMkLst>
            <pc:docMk/>
            <pc:sldMk cId="1019936381" sldId="256"/>
            <ac:spMk id="27" creationId="{7D3B8B6B-ED21-3945-AAC9-F70BA0586AD9}"/>
          </ac:spMkLst>
        </pc:spChg>
        <pc:spChg chg="del">
          <ac:chgData name="France Côté" userId="491ff76e-7bd0-4aca-bb65-325f4c6ba843" providerId="ADAL" clId="{3C866953-DF8E-3F4C-9692-3415286BBDF5}" dt="2024-11-08T16:42:10.243" v="3" actId="478"/>
          <ac:spMkLst>
            <pc:docMk/>
            <pc:sldMk cId="1019936381" sldId="256"/>
            <ac:spMk id="28" creationId="{6A89EA50-F910-9BD6-9CF6-6E21F8C5B9AA}"/>
          </ac:spMkLst>
        </pc:spChg>
        <pc:spChg chg="mod">
          <ac:chgData name="France Côté" userId="491ff76e-7bd0-4aca-bb65-325f4c6ba843" providerId="ADAL" clId="{3C866953-DF8E-3F4C-9692-3415286BBDF5}" dt="2024-11-08T16:43:05.837" v="5"/>
          <ac:spMkLst>
            <pc:docMk/>
            <pc:sldMk cId="1019936381" sldId="256"/>
            <ac:spMk id="59" creationId="{9FB985A4-9185-58B3-A9A4-393B676E96BE}"/>
          </ac:spMkLst>
        </pc:spChg>
        <pc:spChg chg="mod">
          <ac:chgData name="France Côté" userId="491ff76e-7bd0-4aca-bb65-325f4c6ba843" providerId="ADAL" clId="{3C866953-DF8E-3F4C-9692-3415286BBDF5}" dt="2024-11-08T16:43:05.837" v="5"/>
          <ac:spMkLst>
            <pc:docMk/>
            <pc:sldMk cId="1019936381" sldId="256"/>
            <ac:spMk id="65" creationId="{7C45461E-4CC2-0A05-2FE6-57C896FE5F9B}"/>
          </ac:spMkLst>
        </pc:spChg>
        <pc:spChg chg="mod">
          <ac:chgData name="France Côté" userId="491ff76e-7bd0-4aca-bb65-325f4c6ba843" providerId="ADAL" clId="{3C866953-DF8E-3F4C-9692-3415286BBDF5}" dt="2024-11-08T16:43:05.837" v="5"/>
          <ac:spMkLst>
            <pc:docMk/>
            <pc:sldMk cId="1019936381" sldId="256"/>
            <ac:spMk id="66" creationId="{6519FB8D-AF75-394A-91DC-29E44EEAD9BD}"/>
          </ac:spMkLst>
        </pc:spChg>
        <pc:spChg chg="mod">
          <ac:chgData name="France Côté" userId="491ff76e-7bd0-4aca-bb65-325f4c6ba843" providerId="ADAL" clId="{3C866953-DF8E-3F4C-9692-3415286BBDF5}" dt="2024-11-08T16:43:05.837" v="5"/>
          <ac:spMkLst>
            <pc:docMk/>
            <pc:sldMk cId="1019936381" sldId="256"/>
            <ac:spMk id="67" creationId="{962D0158-56D1-8BF4-16D9-E339D03BB773}"/>
          </ac:spMkLst>
        </pc:spChg>
        <pc:spChg chg="mod">
          <ac:chgData name="France Côté" userId="491ff76e-7bd0-4aca-bb65-325f4c6ba843" providerId="ADAL" clId="{3C866953-DF8E-3F4C-9692-3415286BBDF5}" dt="2024-11-08T16:43:05.837" v="5"/>
          <ac:spMkLst>
            <pc:docMk/>
            <pc:sldMk cId="1019936381" sldId="256"/>
            <ac:spMk id="68" creationId="{882E04E9-9F05-1583-2CE8-EFFCB3200DE8}"/>
          </ac:spMkLst>
        </pc:spChg>
        <pc:spChg chg="mod">
          <ac:chgData name="France Côté" userId="491ff76e-7bd0-4aca-bb65-325f4c6ba843" providerId="ADAL" clId="{3C866953-DF8E-3F4C-9692-3415286BBDF5}" dt="2024-11-08T16:43:05.837" v="5"/>
          <ac:spMkLst>
            <pc:docMk/>
            <pc:sldMk cId="1019936381" sldId="256"/>
            <ac:spMk id="69" creationId="{215A6E62-6362-DFE2-E578-F3B51401DBF7}"/>
          </ac:spMkLst>
        </pc:spChg>
        <pc:grpChg chg="add mod">
          <ac:chgData name="France Côté" userId="491ff76e-7bd0-4aca-bb65-325f4c6ba843" providerId="ADAL" clId="{3C866953-DF8E-3F4C-9692-3415286BBDF5}" dt="2024-11-08T16:43:08.465" v="6" actId="1076"/>
          <ac:grpSpMkLst>
            <pc:docMk/>
            <pc:sldMk cId="1019936381" sldId="256"/>
            <ac:grpSpMk id="58" creationId="{EF27F0BE-3B6D-59AE-C2E8-A356A75DB465}"/>
          </ac:grpSpMkLst>
        </pc:grpChg>
        <pc:grpChg chg="mod">
          <ac:chgData name="France Côté" userId="491ff76e-7bd0-4aca-bb65-325f4c6ba843" providerId="ADAL" clId="{3C866953-DF8E-3F4C-9692-3415286BBDF5}" dt="2024-11-08T16:43:05.837" v="5"/>
          <ac:grpSpMkLst>
            <pc:docMk/>
            <pc:sldMk cId="1019936381" sldId="256"/>
            <ac:grpSpMk id="60" creationId="{B6339AAA-34CB-60F4-5E3A-F3BF82BBB6B7}"/>
          </ac:grpSpMkLst>
        </pc:grpChg>
        <pc:grpChg chg="mod">
          <ac:chgData name="France Côté" userId="491ff76e-7bd0-4aca-bb65-325f4c6ba843" providerId="ADAL" clId="{3C866953-DF8E-3F4C-9692-3415286BBDF5}" dt="2024-11-08T16:43:05.837" v="5"/>
          <ac:grpSpMkLst>
            <pc:docMk/>
            <pc:sldMk cId="1019936381" sldId="256"/>
            <ac:grpSpMk id="61" creationId="{0D20983A-9EAB-F47F-CEEB-396422CBAB25}"/>
          </ac:grpSpMkLst>
        </pc:grpChg>
        <pc:picChg chg="del">
          <ac:chgData name="France Côté" userId="491ff76e-7bd0-4aca-bb65-325f4c6ba843" providerId="ADAL" clId="{3C866953-DF8E-3F4C-9692-3415286BBDF5}" dt="2024-11-08T16:42:16.860" v="4" actId="478"/>
          <ac:picMkLst>
            <pc:docMk/>
            <pc:sldMk cId="1019936381" sldId="256"/>
            <ac:picMk id="45" creationId="{883CE3CB-3523-44E0-46CE-EBE8899CC0AD}"/>
          </ac:picMkLst>
        </pc:picChg>
        <pc:picChg chg="mod">
          <ac:chgData name="France Côté" userId="491ff76e-7bd0-4aca-bb65-325f4c6ba843" providerId="ADAL" clId="{3C866953-DF8E-3F4C-9692-3415286BBDF5}" dt="2024-11-08T16:43:05.837" v="5"/>
          <ac:picMkLst>
            <pc:docMk/>
            <pc:sldMk cId="1019936381" sldId="256"/>
            <ac:picMk id="63" creationId="{857A64D8-CC78-A275-1063-AD2F6B1C863B}"/>
          </ac:picMkLst>
        </pc:picChg>
        <pc:picChg chg="mod">
          <ac:chgData name="France Côté" userId="491ff76e-7bd0-4aca-bb65-325f4c6ba843" providerId="ADAL" clId="{3C866953-DF8E-3F4C-9692-3415286BBDF5}" dt="2024-11-08T16:43:05.837" v="5"/>
          <ac:picMkLst>
            <pc:docMk/>
            <pc:sldMk cId="1019936381" sldId="256"/>
            <ac:picMk id="64" creationId="{1719A5FC-E16D-4DCA-5D80-0B9AEDF09EF7}"/>
          </ac:picMkLst>
        </pc:picChg>
        <pc:cxnChg chg="mod">
          <ac:chgData name="France Côté" userId="491ff76e-7bd0-4aca-bb65-325f4c6ba843" providerId="ADAL" clId="{3C866953-DF8E-3F4C-9692-3415286BBDF5}" dt="2024-11-08T16:43:05.837" v="5"/>
          <ac:cxnSpMkLst>
            <pc:docMk/>
            <pc:sldMk cId="1019936381" sldId="256"/>
            <ac:cxnSpMk id="62" creationId="{38C6FBC0-1B30-391B-D65C-69C2A44D5264}"/>
          </ac:cxnSpMkLst>
        </pc:cxnChg>
      </pc:sldChg>
      <pc:sldChg chg="del">
        <pc:chgData name="France Côté" userId="491ff76e-7bd0-4aca-bb65-325f4c6ba843" providerId="ADAL" clId="{3C866953-DF8E-3F4C-9692-3415286BBDF5}" dt="2024-11-08T16:43:15.289" v="7" actId="2696"/>
        <pc:sldMkLst>
          <pc:docMk/>
          <pc:sldMk cId="3163147921" sldId="257"/>
        </pc:sldMkLst>
      </pc:sldChg>
      <pc:sldChg chg="addSp delSp modSp mod">
        <pc:chgData name="France Côté" userId="491ff76e-7bd0-4aca-bb65-325f4c6ba843" providerId="ADAL" clId="{3C866953-DF8E-3F4C-9692-3415286BBDF5}" dt="2024-11-08T16:47:14.722" v="90" actId="1036"/>
        <pc:sldMkLst>
          <pc:docMk/>
          <pc:sldMk cId="1335229401" sldId="258"/>
        </pc:sldMkLst>
        <pc:spChg chg="del">
          <ac:chgData name="France Côté" userId="491ff76e-7bd0-4aca-bb65-325f4c6ba843" providerId="ADAL" clId="{3C866953-DF8E-3F4C-9692-3415286BBDF5}" dt="2024-11-08T16:43:24.112" v="10" actId="478"/>
          <ac:spMkLst>
            <pc:docMk/>
            <pc:sldMk cId="1335229401" sldId="258"/>
            <ac:spMk id="2" creationId="{41A18460-8AE6-A324-6A2B-5C42549F6075}"/>
          </ac:spMkLst>
        </pc:spChg>
        <pc:spChg chg="mod">
          <ac:chgData name="France Côté" userId="491ff76e-7bd0-4aca-bb65-325f4c6ba843" providerId="ADAL" clId="{3C866953-DF8E-3F4C-9692-3415286BBDF5}" dt="2024-11-08T16:46:38.373" v="62" actId="20577"/>
          <ac:spMkLst>
            <pc:docMk/>
            <pc:sldMk cId="1335229401" sldId="258"/>
            <ac:spMk id="10" creationId="{433129C9-FDC8-A050-11AC-4CCE46060890}"/>
          </ac:spMkLst>
        </pc:spChg>
        <pc:spChg chg="mod">
          <ac:chgData name="France Côté" userId="491ff76e-7bd0-4aca-bb65-325f4c6ba843" providerId="ADAL" clId="{3C866953-DF8E-3F4C-9692-3415286BBDF5}" dt="2024-11-08T16:46:41.072" v="63" actId="20577"/>
          <ac:spMkLst>
            <pc:docMk/>
            <pc:sldMk cId="1335229401" sldId="258"/>
            <ac:spMk id="11" creationId="{663ED4C8-600F-C490-3F82-09B306714052}"/>
          </ac:spMkLst>
        </pc:spChg>
        <pc:spChg chg="mod">
          <ac:chgData name="France Côté" userId="491ff76e-7bd0-4aca-bb65-325f4c6ba843" providerId="ADAL" clId="{3C866953-DF8E-3F4C-9692-3415286BBDF5}" dt="2024-11-08T16:46:42.946" v="64" actId="20577"/>
          <ac:spMkLst>
            <pc:docMk/>
            <pc:sldMk cId="1335229401" sldId="258"/>
            <ac:spMk id="14" creationId="{613D0AE1-81E0-5B83-A6C1-0C8D99153259}"/>
          </ac:spMkLst>
        </pc:spChg>
        <pc:spChg chg="mod">
          <ac:chgData name="France Côté" userId="491ff76e-7bd0-4aca-bb65-325f4c6ba843" providerId="ADAL" clId="{3C866953-DF8E-3F4C-9692-3415286BBDF5}" dt="2024-11-08T16:46:47.243" v="67" actId="20577"/>
          <ac:spMkLst>
            <pc:docMk/>
            <pc:sldMk cId="1335229401" sldId="258"/>
            <ac:spMk id="17" creationId="{6EEA822E-C4DE-D56A-E63B-9370FDF10BD4}"/>
          </ac:spMkLst>
        </pc:spChg>
        <pc:spChg chg="mod">
          <ac:chgData name="France Côté" userId="491ff76e-7bd0-4aca-bb65-325f4c6ba843" providerId="ADAL" clId="{3C866953-DF8E-3F4C-9692-3415286BBDF5}" dt="2024-11-08T16:46:50.672" v="68" actId="20577"/>
          <ac:spMkLst>
            <pc:docMk/>
            <pc:sldMk cId="1335229401" sldId="258"/>
            <ac:spMk id="18" creationId="{44A7F2EE-164C-64A5-4228-CBF1C468AA17}"/>
          </ac:spMkLst>
        </pc:spChg>
        <pc:spChg chg="mod">
          <ac:chgData name="France Côté" userId="491ff76e-7bd0-4aca-bb65-325f4c6ba843" providerId="ADAL" clId="{3C866953-DF8E-3F4C-9692-3415286BBDF5}" dt="2024-11-08T16:46:52.957" v="69" actId="20577"/>
          <ac:spMkLst>
            <pc:docMk/>
            <pc:sldMk cId="1335229401" sldId="258"/>
            <ac:spMk id="19" creationId="{E204BA0C-6FE1-1F20-170C-4551F6BF2DAC}"/>
          </ac:spMkLst>
        </pc:spChg>
        <pc:spChg chg="del">
          <ac:chgData name="France Côté" userId="491ff76e-7bd0-4aca-bb65-325f4c6ba843" providerId="ADAL" clId="{3C866953-DF8E-3F4C-9692-3415286BBDF5}" dt="2024-11-08T16:43:18.154" v="8" actId="478"/>
          <ac:spMkLst>
            <pc:docMk/>
            <pc:sldMk cId="1335229401" sldId="258"/>
            <ac:spMk id="27" creationId="{7D3B8B6B-ED21-3945-AAC9-F70BA0586AD9}"/>
          </ac:spMkLst>
        </pc:spChg>
        <pc:spChg chg="del">
          <ac:chgData name="France Côté" userId="491ff76e-7bd0-4aca-bb65-325f4c6ba843" providerId="ADAL" clId="{3C866953-DF8E-3F4C-9692-3415286BBDF5}" dt="2024-11-08T16:43:19.457" v="9" actId="478"/>
          <ac:spMkLst>
            <pc:docMk/>
            <pc:sldMk cId="1335229401" sldId="258"/>
            <ac:spMk id="28" creationId="{6A89EA50-F910-9BD6-9CF6-6E21F8C5B9AA}"/>
          </ac:spMkLst>
        </pc:spChg>
        <pc:spChg chg="mod">
          <ac:chgData name="France Côté" userId="491ff76e-7bd0-4aca-bb65-325f4c6ba843" providerId="ADAL" clId="{3C866953-DF8E-3F4C-9692-3415286BBDF5}" dt="2024-11-08T16:47:07.659" v="71"/>
          <ac:spMkLst>
            <pc:docMk/>
            <pc:sldMk cId="1335229401" sldId="258"/>
            <ac:spMk id="34" creationId="{30D5DFBC-9186-71C7-7E45-16313AFDD77B}"/>
          </ac:spMkLst>
        </pc:spChg>
        <pc:spChg chg="mod">
          <ac:chgData name="France Côté" userId="491ff76e-7bd0-4aca-bb65-325f4c6ba843" providerId="ADAL" clId="{3C866953-DF8E-3F4C-9692-3415286BBDF5}" dt="2024-11-08T16:47:07.659" v="71"/>
          <ac:spMkLst>
            <pc:docMk/>
            <pc:sldMk cId="1335229401" sldId="258"/>
            <ac:spMk id="37" creationId="{D37D4539-2BAB-0A12-7DF2-5916F914EF71}"/>
          </ac:spMkLst>
        </pc:spChg>
        <pc:spChg chg="mod">
          <ac:chgData name="France Côté" userId="491ff76e-7bd0-4aca-bb65-325f4c6ba843" providerId="ADAL" clId="{3C866953-DF8E-3F4C-9692-3415286BBDF5}" dt="2024-11-08T16:47:07.659" v="71"/>
          <ac:spMkLst>
            <pc:docMk/>
            <pc:sldMk cId="1335229401" sldId="258"/>
            <ac:spMk id="38" creationId="{4A00CE72-92AB-B0BC-FB75-AAE7BEF46525}"/>
          </ac:spMkLst>
        </pc:spChg>
        <pc:spChg chg="mod">
          <ac:chgData name="France Côté" userId="491ff76e-7bd0-4aca-bb65-325f4c6ba843" providerId="ADAL" clId="{3C866953-DF8E-3F4C-9692-3415286BBDF5}" dt="2024-11-08T16:47:07.659" v="71"/>
          <ac:spMkLst>
            <pc:docMk/>
            <pc:sldMk cId="1335229401" sldId="258"/>
            <ac:spMk id="39" creationId="{D5D18D47-D7DE-AA30-211A-82C7066CAF78}"/>
          </ac:spMkLst>
        </pc:spChg>
        <pc:spChg chg="mod">
          <ac:chgData name="France Côté" userId="491ff76e-7bd0-4aca-bb65-325f4c6ba843" providerId="ADAL" clId="{3C866953-DF8E-3F4C-9692-3415286BBDF5}" dt="2024-11-08T16:47:07.659" v="71"/>
          <ac:spMkLst>
            <pc:docMk/>
            <pc:sldMk cId="1335229401" sldId="258"/>
            <ac:spMk id="40" creationId="{612FFD1F-0AE5-6EB6-1B78-769CE96CA5D0}"/>
          </ac:spMkLst>
        </pc:spChg>
        <pc:spChg chg="mod">
          <ac:chgData name="France Côté" userId="491ff76e-7bd0-4aca-bb65-325f4c6ba843" providerId="ADAL" clId="{3C866953-DF8E-3F4C-9692-3415286BBDF5}" dt="2024-11-08T16:47:07.659" v="71"/>
          <ac:spMkLst>
            <pc:docMk/>
            <pc:sldMk cId="1335229401" sldId="258"/>
            <ac:spMk id="41" creationId="{53053819-8A39-D671-4F77-3B11893A7D22}"/>
          </ac:spMkLst>
        </pc:spChg>
        <pc:spChg chg="mod">
          <ac:chgData name="France Côté" userId="491ff76e-7bd0-4aca-bb65-325f4c6ba843" providerId="ADAL" clId="{3C866953-DF8E-3F4C-9692-3415286BBDF5}" dt="2024-11-08T16:47:07.659" v="71"/>
          <ac:spMkLst>
            <pc:docMk/>
            <pc:sldMk cId="1335229401" sldId="258"/>
            <ac:spMk id="64" creationId="{1AE5C10F-32E5-18A5-EED0-E1F20ACBB8B2}"/>
          </ac:spMkLst>
        </pc:spChg>
        <pc:spChg chg="mod">
          <ac:chgData name="France Côté" userId="491ff76e-7bd0-4aca-bb65-325f4c6ba843" providerId="ADAL" clId="{3C866953-DF8E-3F4C-9692-3415286BBDF5}" dt="2024-11-08T16:47:07.659" v="71"/>
          <ac:spMkLst>
            <pc:docMk/>
            <pc:sldMk cId="1335229401" sldId="258"/>
            <ac:spMk id="65" creationId="{77340529-6FAB-7D1D-9A28-79B79852A4BB}"/>
          </ac:spMkLst>
        </pc:spChg>
        <pc:spChg chg="mod">
          <ac:chgData name="France Côté" userId="491ff76e-7bd0-4aca-bb65-325f4c6ba843" providerId="ADAL" clId="{3C866953-DF8E-3F4C-9692-3415286BBDF5}" dt="2024-11-08T16:47:07.659" v="71"/>
          <ac:spMkLst>
            <pc:docMk/>
            <pc:sldMk cId="1335229401" sldId="258"/>
            <ac:spMk id="66" creationId="{8E44DF07-B2F8-74BF-CBF4-94F2DB1E86BE}"/>
          </ac:spMkLst>
        </pc:spChg>
        <pc:spChg chg="mod">
          <ac:chgData name="France Côté" userId="491ff76e-7bd0-4aca-bb65-325f4c6ba843" providerId="ADAL" clId="{3C866953-DF8E-3F4C-9692-3415286BBDF5}" dt="2024-11-08T16:47:07.659" v="71"/>
          <ac:spMkLst>
            <pc:docMk/>
            <pc:sldMk cId="1335229401" sldId="258"/>
            <ac:spMk id="67" creationId="{C6322190-E076-7930-DFCA-D110E8B0B9B9}"/>
          </ac:spMkLst>
        </pc:spChg>
        <pc:spChg chg="mod">
          <ac:chgData name="France Côté" userId="491ff76e-7bd0-4aca-bb65-325f4c6ba843" providerId="ADAL" clId="{3C866953-DF8E-3F4C-9692-3415286BBDF5}" dt="2024-11-08T16:47:07.659" v="71"/>
          <ac:spMkLst>
            <pc:docMk/>
            <pc:sldMk cId="1335229401" sldId="258"/>
            <ac:spMk id="68" creationId="{61875CC4-F80D-BC3F-85F8-BAF2D626E0BA}"/>
          </ac:spMkLst>
        </pc:spChg>
        <pc:spChg chg="mod">
          <ac:chgData name="France Côté" userId="491ff76e-7bd0-4aca-bb65-325f4c6ba843" providerId="ADAL" clId="{3C866953-DF8E-3F4C-9692-3415286BBDF5}" dt="2024-11-08T16:47:07.659" v="71"/>
          <ac:spMkLst>
            <pc:docMk/>
            <pc:sldMk cId="1335229401" sldId="258"/>
            <ac:spMk id="69" creationId="{A0AED540-CA8D-66DF-36FE-91FDAEBBED7F}"/>
          </ac:spMkLst>
        </pc:spChg>
        <pc:grpChg chg="del">
          <ac:chgData name="France Côté" userId="491ff76e-7bd0-4aca-bb65-325f4c6ba843" providerId="ADAL" clId="{3C866953-DF8E-3F4C-9692-3415286BBDF5}" dt="2024-11-08T16:47:03.796" v="70" actId="478"/>
          <ac:grpSpMkLst>
            <pc:docMk/>
            <pc:sldMk cId="1335229401" sldId="258"/>
            <ac:grpSpMk id="7" creationId="{FCC9ED08-A804-F358-6EB8-E1BD0EB4C876}"/>
          </ac:grpSpMkLst>
        </pc:grpChg>
        <pc:grpChg chg="add mod">
          <ac:chgData name="France Côté" userId="491ff76e-7bd0-4aca-bb65-325f4c6ba843" providerId="ADAL" clId="{3C866953-DF8E-3F4C-9692-3415286BBDF5}" dt="2024-11-08T16:47:14.722" v="90" actId="1036"/>
          <ac:grpSpMkLst>
            <pc:docMk/>
            <pc:sldMk cId="1335229401" sldId="258"/>
            <ac:grpSpMk id="24" creationId="{D80D63ED-BC69-6C33-4704-CEDB825BBFB2}"/>
          </ac:grpSpMkLst>
        </pc:grpChg>
        <pc:grpChg chg="mod">
          <ac:chgData name="France Côté" userId="491ff76e-7bd0-4aca-bb65-325f4c6ba843" providerId="ADAL" clId="{3C866953-DF8E-3F4C-9692-3415286BBDF5}" dt="2024-11-08T16:47:07.659" v="71"/>
          <ac:grpSpMkLst>
            <pc:docMk/>
            <pc:sldMk cId="1335229401" sldId="258"/>
            <ac:grpSpMk id="35" creationId="{7ADD45E6-F299-61E3-8111-A73C6BB4BA6A}"/>
          </ac:grpSpMkLst>
        </pc:grpChg>
        <pc:grpChg chg="mod">
          <ac:chgData name="France Côté" userId="491ff76e-7bd0-4aca-bb65-325f4c6ba843" providerId="ADAL" clId="{3C866953-DF8E-3F4C-9692-3415286BBDF5}" dt="2024-11-08T16:47:07.659" v="71"/>
          <ac:grpSpMkLst>
            <pc:docMk/>
            <pc:sldMk cId="1335229401" sldId="258"/>
            <ac:grpSpMk id="36" creationId="{B1E32F05-B53B-0450-739B-EF0B176257DD}"/>
          </ac:grpSpMkLst>
        </pc:grpChg>
      </pc:sldChg>
      <pc:sldChg chg="del">
        <pc:chgData name="France Côté" userId="491ff76e-7bd0-4aca-bb65-325f4c6ba843" providerId="ADAL" clId="{3C866953-DF8E-3F4C-9692-3415286BBDF5}" dt="2024-11-08T16:41:37.193" v="1" actId="2696"/>
        <pc:sldMkLst>
          <pc:docMk/>
          <pc:sldMk cId="321237087" sldId="259"/>
        </pc:sldMkLst>
      </pc:sldChg>
      <pc:sldChg chg="del">
        <pc:chgData name="France Côté" userId="491ff76e-7bd0-4aca-bb65-325f4c6ba843" providerId="ADAL" clId="{3C866953-DF8E-3F4C-9692-3415286BBDF5}" dt="2024-11-08T16:41:36.041" v="0" actId="2696"/>
        <pc:sldMkLst>
          <pc:docMk/>
          <pc:sldMk cId="780272175" sldId="260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FB58520-35DE-7494-F30E-040BBB9C083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051D6F31-82F2-40C3-F40D-ED743EFCF1E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CA"/>
              <a:t>Modifier le style des sous-titres du masque</a:t>
            </a:r>
            <a:endParaRPr lang="en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E39E6FC-82F4-042A-3131-D2E1D67059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141B9-53DD-D643-A795-43480A22EB8D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3105939-CA52-178B-2DDE-59A683A7B7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B37989A-60D9-2C84-ECEF-E81C909832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726A8-F18D-AD44-921C-7D573297C8DC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937636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59B0F3F-4E5B-9750-4131-7BBC11B833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1435C6CD-6919-34F4-9CA0-5194A3A91B9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2AEDBDC-B112-A2C0-CC0F-CCA513FB60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141B9-53DD-D643-A795-43480A22EB8D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57A3115-64D9-41B6-1191-E4B3B7944C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807AC91-5EA0-4819-45A6-8AEE0F4F43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726A8-F18D-AD44-921C-7D573297C8DC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495821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4AEB9E92-4696-7306-858D-51BE654AD7D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B9344CD6-0DAE-1B9A-F95D-009346F6CFF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3C3D01E-23FE-77BC-F793-C6977AF0E9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141B9-53DD-D643-A795-43480A22EB8D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6F4C8F3-7ABA-72F0-D406-1C4F01E2AD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9764AA9-65A3-16AB-6901-C05CF4ADC8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726A8-F18D-AD44-921C-7D573297C8DC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793100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0FED445-A6E3-5BF2-0D8E-4B8310CC30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B45B459-70C9-F849-341B-1F22AC088E6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9B3FE57-3229-F9A5-D173-63D280EA13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141B9-53DD-D643-A795-43480A22EB8D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437FB0C-C670-1DCC-68B1-E4F6D7666A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3E1AEB6-43E1-F6BE-1E18-E8AA7F54B3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726A8-F18D-AD44-921C-7D573297C8DC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401171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820E83B-23EE-F01E-B3D5-406FDC9446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2E750567-1F8D-EA8D-423D-65B284B99E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378AF01-02BE-93FE-9F92-79579704B5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141B9-53DD-D643-A795-43480A22EB8D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E08169A-C05B-F552-8C84-7596F7AF53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D1BAB08-50C8-432B-4729-B9B45D38DE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726A8-F18D-AD44-921C-7D573297C8DC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047853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676B1F9-E731-EDDD-F559-C48B68A776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B1521641-6D9E-1DBC-4BA3-36A6B01DFC8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5C52529E-CE6D-36E6-922E-EBB8B201D9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01E5C92A-6AD3-0920-23FE-85B7015645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141B9-53DD-D643-A795-43480A22EB8D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F1E5742-46E0-EAE8-B6E5-CA4212924A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83B26C4-1914-0CB2-914A-FF7F2F20FC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726A8-F18D-AD44-921C-7D573297C8DC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1484473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10FFC70-330A-744A-1894-20AF85200D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39E2CA1B-C7C0-F6D4-C913-40991B402F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3CCB6C9C-4749-06EC-F7FB-78F8A287585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5D8DD98A-E7DC-007F-B021-D44977DF068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AB94F0FE-FDD8-6815-CAEF-14A5A6569E0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7F8438D0-9073-BEA3-B740-75DAE5FD2D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141B9-53DD-D643-A795-43480A22EB8D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24761252-B408-CF1E-717D-35C24DE640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05161C34-067B-D0C4-7FDE-8B6D3BEE49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726A8-F18D-AD44-921C-7D573297C8DC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149091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BF0F1D7-83AA-D9AE-75AA-3528249130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6BA68342-8D43-FE08-8E34-A76EA4D02C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141B9-53DD-D643-A795-43480A22EB8D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4AB3E4C6-FA9E-3562-47B0-14C079B8DD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2DA26D99-2A08-08C9-4B52-0C966154B1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726A8-F18D-AD44-921C-7D573297C8DC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946092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D191AACE-566F-A32E-3063-64517B21E5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141B9-53DD-D643-A795-43480A22EB8D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EF8317E9-588D-B139-C938-D8038C02E1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3A675240-71F4-87E7-5F9E-C0A850CA7C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726A8-F18D-AD44-921C-7D573297C8DC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278618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6B71B44-0F46-A292-C0D5-CEBD808EEC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AF6411E-104A-C12D-E275-96DABB2E3BA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CBEEF0C2-1F61-240B-E21D-9C5BEF15DF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15E1AA3-4525-5E25-764A-A9B708C024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141B9-53DD-D643-A795-43480A22EB8D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9784A41-ED38-381B-3323-97D7023505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237B1CB-CAB7-FB0B-16BF-8543B6D906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726A8-F18D-AD44-921C-7D573297C8DC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760276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3AB7C30-DF57-B697-BDA2-06802C35D3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6E9343E4-99E4-2AA0-9559-D63EE4C6DEA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231F2E5F-3B9A-025F-8932-4B5CFA3B70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DE9FA1BB-1295-3B88-55D8-43659B63EB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141B9-53DD-D643-A795-43480A22EB8D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A22D2991-6BD4-C1BF-AEB2-A43123449D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09023E0E-B417-ED18-66D1-AB812B55A2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726A8-F18D-AD44-921C-7D573297C8DC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9237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ACCDC181-EF50-0635-21C9-D7E336BCBB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C23957A7-6D1A-E007-1B31-FB9C7D648A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58D5675-6051-0BDB-0723-89FFFBEBF0D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F141B9-53DD-D643-A795-43480A22EB8D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807E28B-08BE-8BDB-4DEE-98411A03B21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A8115BA-B34D-5F5F-B5B7-C6F703358CB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726A8-F18D-AD44-921C-7D573297C8DC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814991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Image 8">
            <a:extLst>
              <a:ext uri="{FF2B5EF4-FFF2-40B4-BE49-F238E27FC236}">
                <a16:creationId xmlns:a16="http://schemas.microsoft.com/office/drawing/2014/main" id="{7DDB3744-64D9-89AB-3FE3-E8AD376EA3F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3550" t="13155" r="18092" b="66686"/>
          <a:stretch/>
        </p:blipFill>
        <p:spPr>
          <a:xfrm>
            <a:off x="1326995" y="1755058"/>
            <a:ext cx="4221481" cy="1297107"/>
          </a:xfrm>
          <a:prstGeom prst="rect">
            <a:avLst/>
          </a:prstGeom>
        </p:spPr>
      </p:pic>
      <p:grpSp>
        <p:nvGrpSpPr>
          <p:cNvPr id="23" name="Groupe 22">
            <a:extLst>
              <a:ext uri="{FF2B5EF4-FFF2-40B4-BE49-F238E27FC236}">
                <a16:creationId xmlns:a16="http://schemas.microsoft.com/office/drawing/2014/main" id="{DC67F4C3-DBAE-801A-4A5D-DE50F4747221}"/>
              </a:ext>
            </a:extLst>
          </p:cNvPr>
          <p:cNvGrpSpPr/>
          <p:nvPr/>
        </p:nvGrpSpPr>
        <p:grpSpPr>
          <a:xfrm>
            <a:off x="1557995" y="460638"/>
            <a:ext cx="3777039" cy="1364974"/>
            <a:chOff x="1557995" y="839779"/>
            <a:chExt cx="3777039" cy="1364974"/>
          </a:xfrm>
        </p:grpSpPr>
        <p:sp>
          <p:nvSpPr>
            <p:cNvPr id="10" name="ZoneTexte 9">
              <a:extLst>
                <a:ext uri="{FF2B5EF4-FFF2-40B4-BE49-F238E27FC236}">
                  <a16:creationId xmlns:a16="http://schemas.microsoft.com/office/drawing/2014/main" id="{433129C9-FDC8-A050-11AC-4CCE46060890}"/>
                </a:ext>
              </a:extLst>
            </p:cNvPr>
            <p:cNvSpPr txBox="1"/>
            <p:nvPr/>
          </p:nvSpPr>
          <p:spPr>
            <a:xfrm rot="16200000">
              <a:off x="1060174" y="1337600"/>
              <a:ext cx="13649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/>
                <a:t>SHAM 1 </a:t>
              </a:r>
            </a:p>
          </p:txBody>
        </p:sp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id="{663ED4C8-600F-C490-3F82-09B306714052}"/>
                </a:ext>
              </a:extLst>
            </p:cNvPr>
            <p:cNvSpPr txBox="1"/>
            <p:nvPr/>
          </p:nvSpPr>
          <p:spPr>
            <a:xfrm rot="16200000">
              <a:off x="1311100" y="1337600"/>
              <a:ext cx="13649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/>
                <a:t>SHAM 2 </a:t>
              </a:r>
            </a:p>
          </p:txBody>
        </p:sp>
        <p:sp>
          <p:nvSpPr>
            <p:cNvPr id="12" name="ZoneTexte 11">
              <a:extLst>
                <a:ext uri="{FF2B5EF4-FFF2-40B4-BE49-F238E27FC236}">
                  <a16:creationId xmlns:a16="http://schemas.microsoft.com/office/drawing/2014/main" id="{5B28D7D0-1686-7BB1-E959-CF90FE9BDEF4}"/>
                </a:ext>
              </a:extLst>
            </p:cNvPr>
            <p:cNvSpPr txBox="1"/>
            <p:nvPr/>
          </p:nvSpPr>
          <p:spPr>
            <a:xfrm rot="16200000">
              <a:off x="1584343" y="1337600"/>
              <a:ext cx="13649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/>
                <a:t>LPS 1 </a:t>
              </a:r>
            </a:p>
          </p:txBody>
        </p:sp>
        <p:sp>
          <p:nvSpPr>
            <p:cNvPr id="13" name="ZoneTexte 12">
              <a:extLst>
                <a:ext uri="{FF2B5EF4-FFF2-40B4-BE49-F238E27FC236}">
                  <a16:creationId xmlns:a16="http://schemas.microsoft.com/office/drawing/2014/main" id="{E7447F15-DF17-6CBA-60F7-88CF36D17E97}"/>
                </a:ext>
              </a:extLst>
            </p:cNvPr>
            <p:cNvSpPr txBox="1"/>
            <p:nvPr/>
          </p:nvSpPr>
          <p:spPr>
            <a:xfrm rot="16200000">
              <a:off x="1852533" y="1337600"/>
              <a:ext cx="13649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/>
                <a:t>LPS 2 </a:t>
              </a:r>
            </a:p>
          </p:txBody>
        </p:sp>
        <p:sp>
          <p:nvSpPr>
            <p:cNvPr id="14" name="ZoneTexte 13">
              <a:extLst>
                <a:ext uri="{FF2B5EF4-FFF2-40B4-BE49-F238E27FC236}">
                  <a16:creationId xmlns:a16="http://schemas.microsoft.com/office/drawing/2014/main" id="{613D0AE1-81E0-5B83-A6C1-0C8D99153259}"/>
                </a:ext>
              </a:extLst>
            </p:cNvPr>
            <p:cNvSpPr txBox="1"/>
            <p:nvPr/>
          </p:nvSpPr>
          <p:spPr>
            <a:xfrm rot="16200000">
              <a:off x="2108512" y="1337600"/>
              <a:ext cx="13649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/>
                <a:t>HSJ633 1-2H</a:t>
              </a:r>
            </a:p>
          </p:txBody>
        </p:sp>
        <p:sp>
          <p:nvSpPr>
            <p:cNvPr id="15" name="ZoneTexte 14">
              <a:extLst>
                <a:ext uri="{FF2B5EF4-FFF2-40B4-BE49-F238E27FC236}">
                  <a16:creationId xmlns:a16="http://schemas.microsoft.com/office/drawing/2014/main" id="{A8CF09F0-B149-2C8F-934C-DDAD6524F184}"/>
                </a:ext>
              </a:extLst>
            </p:cNvPr>
            <p:cNvSpPr txBox="1"/>
            <p:nvPr/>
          </p:nvSpPr>
          <p:spPr>
            <a:xfrm rot="16200000">
              <a:off x="2364491" y="1337600"/>
              <a:ext cx="13649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/>
                <a:t>HSJ633 2-2H</a:t>
              </a:r>
            </a:p>
          </p:txBody>
        </p:sp>
        <p:sp>
          <p:nvSpPr>
            <p:cNvPr id="16" name="ZoneTexte 15">
              <a:extLst>
                <a:ext uri="{FF2B5EF4-FFF2-40B4-BE49-F238E27FC236}">
                  <a16:creationId xmlns:a16="http://schemas.microsoft.com/office/drawing/2014/main" id="{28163057-C816-A982-42AB-FE28BAA9C554}"/>
                </a:ext>
              </a:extLst>
            </p:cNvPr>
            <p:cNvSpPr txBox="1"/>
            <p:nvPr/>
          </p:nvSpPr>
          <p:spPr>
            <a:xfrm rot="16200000">
              <a:off x="2879438" y="1337600"/>
              <a:ext cx="13649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/>
                <a:t>SHAM 1</a:t>
              </a:r>
            </a:p>
          </p:txBody>
        </p:sp>
        <p:sp>
          <p:nvSpPr>
            <p:cNvPr id="17" name="ZoneTexte 16">
              <a:extLst>
                <a:ext uri="{FF2B5EF4-FFF2-40B4-BE49-F238E27FC236}">
                  <a16:creationId xmlns:a16="http://schemas.microsoft.com/office/drawing/2014/main" id="{6EEA822E-C4DE-D56A-E63B-9370FDF10BD4}"/>
                </a:ext>
              </a:extLst>
            </p:cNvPr>
            <p:cNvSpPr txBox="1"/>
            <p:nvPr/>
          </p:nvSpPr>
          <p:spPr>
            <a:xfrm rot="16200000">
              <a:off x="3152514" y="1337600"/>
              <a:ext cx="13649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/>
                <a:t>LPS 3 </a:t>
              </a:r>
            </a:p>
          </p:txBody>
        </p:sp>
        <p:sp>
          <p:nvSpPr>
            <p:cNvPr id="18" name="ZoneTexte 17">
              <a:extLst>
                <a:ext uri="{FF2B5EF4-FFF2-40B4-BE49-F238E27FC236}">
                  <a16:creationId xmlns:a16="http://schemas.microsoft.com/office/drawing/2014/main" id="{44A7F2EE-164C-64A5-4228-CBF1C468AA17}"/>
                </a:ext>
              </a:extLst>
            </p:cNvPr>
            <p:cNvSpPr txBox="1"/>
            <p:nvPr/>
          </p:nvSpPr>
          <p:spPr>
            <a:xfrm rot="16200000">
              <a:off x="3394386" y="1337600"/>
              <a:ext cx="13649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/>
                <a:t>LPS 4</a:t>
              </a:r>
            </a:p>
          </p:txBody>
        </p:sp>
        <p:sp>
          <p:nvSpPr>
            <p:cNvPr id="19" name="ZoneTexte 18">
              <a:extLst>
                <a:ext uri="{FF2B5EF4-FFF2-40B4-BE49-F238E27FC236}">
                  <a16:creationId xmlns:a16="http://schemas.microsoft.com/office/drawing/2014/main" id="{E204BA0C-6FE1-1F20-170C-4551F6BF2DAC}"/>
                </a:ext>
              </a:extLst>
            </p:cNvPr>
            <p:cNvSpPr txBox="1"/>
            <p:nvPr/>
          </p:nvSpPr>
          <p:spPr>
            <a:xfrm rot="16200000">
              <a:off x="3636258" y="1337600"/>
              <a:ext cx="13649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/>
                <a:t>LPS 5</a:t>
              </a:r>
            </a:p>
          </p:txBody>
        </p:sp>
        <p:sp>
          <p:nvSpPr>
            <p:cNvPr id="20" name="ZoneTexte 19">
              <a:extLst>
                <a:ext uri="{FF2B5EF4-FFF2-40B4-BE49-F238E27FC236}">
                  <a16:creationId xmlns:a16="http://schemas.microsoft.com/office/drawing/2014/main" id="{7E1C9CDD-4CD2-1C25-DC2F-E1E461D65BF9}"/>
                </a:ext>
              </a:extLst>
            </p:cNvPr>
            <p:cNvSpPr txBox="1"/>
            <p:nvPr/>
          </p:nvSpPr>
          <p:spPr>
            <a:xfrm rot="16200000">
              <a:off x="3943712" y="1337600"/>
              <a:ext cx="13649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/>
                <a:t>HSJ633 3-2H</a:t>
              </a:r>
            </a:p>
          </p:txBody>
        </p:sp>
        <p:sp>
          <p:nvSpPr>
            <p:cNvPr id="21" name="ZoneTexte 20">
              <a:extLst>
                <a:ext uri="{FF2B5EF4-FFF2-40B4-BE49-F238E27FC236}">
                  <a16:creationId xmlns:a16="http://schemas.microsoft.com/office/drawing/2014/main" id="{F7719E9D-4C32-A9D6-2ECD-2D465BCCF998}"/>
                </a:ext>
              </a:extLst>
            </p:cNvPr>
            <p:cNvSpPr txBox="1"/>
            <p:nvPr/>
          </p:nvSpPr>
          <p:spPr>
            <a:xfrm rot="16200000">
              <a:off x="4194638" y="1337600"/>
              <a:ext cx="13649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/>
                <a:t>HSJ633 4-2H</a:t>
              </a:r>
            </a:p>
          </p:txBody>
        </p:sp>
        <p:sp>
          <p:nvSpPr>
            <p:cNvPr id="22" name="ZoneTexte 21">
              <a:extLst>
                <a:ext uri="{FF2B5EF4-FFF2-40B4-BE49-F238E27FC236}">
                  <a16:creationId xmlns:a16="http://schemas.microsoft.com/office/drawing/2014/main" id="{57B1B965-77E1-0D23-AB70-4C7CD5D2F734}"/>
                </a:ext>
              </a:extLst>
            </p:cNvPr>
            <p:cNvSpPr txBox="1"/>
            <p:nvPr/>
          </p:nvSpPr>
          <p:spPr>
            <a:xfrm rot="16200000">
              <a:off x="4467881" y="1337600"/>
              <a:ext cx="13649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/>
                <a:t>HSJ633 5-2H</a:t>
              </a:r>
            </a:p>
          </p:txBody>
        </p:sp>
      </p:grpSp>
      <p:pic>
        <p:nvPicPr>
          <p:cNvPr id="24" name="Image 23">
            <a:extLst>
              <a:ext uri="{FF2B5EF4-FFF2-40B4-BE49-F238E27FC236}">
                <a16:creationId xmlns:a16="http://schemas.microsoft.com/office/drawing/2014/main" id="{A445BF95-2D22-3103-E5C5-F655EA956F3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8164" t="34211" r="18092" b="53311"/>
          <a:stretch/>
        </p:blipFill>
        <p:spPr>
          <a:xfrm>
            <a:off x="914399" y="3311913"/>
            <a:ext cx="4691605" cy="802888"/>
          </a:xfrm>
          <a:prstGeom prst="rect">
            <a:avLst/>
          </a:prstGeom>
        </p:spPr>
      </p:pic>
      <p:sp>
        <p:nvSpPr>
          <p:cNvPr id="25" name="ZoneTexte 24">
            <a:extLst>
              <a:ext uri="{FF2B5EF4-FFF2-40B4-BE49-F238E27FC236}">
                <a16:creationId xmlns:a16="http://schemas.microsoft.com/office/drawing/2014/main" id="{74676D1E-42F3-D74F-4E0E-7529C36350AF}"/>
              </a:ext>
            </a:extLst>
          </p:cNvPr>
          <p:cNvSpPr txBox="1"/>
          <p:nvPr/>
        </p:nvSpPr>
        <p:spPr>
          <a:xfrm>
            <a:off x="0" y="2166678"/>
            <a:ext cx="14585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p-STAT3</a:t>
            </a: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6FC70EF0-60E1-82A5-F6C1-5EB430020399}"/>
              </a:ext>
            </a:extLst>
          </p:cNvPr>
          <p:cNvSpPr txBox="1"/>
          <p:nvPr/>
        </p:nvSpPr>
        <p:spPr>
          <a:xfrm>
            <a:off x="144963" y="3528691"/>
            <a:ext cx="14585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COXIV</a:t>
            </a:r>
          </a:p>
        </p:txBody>
      </p:sp>
      <p:pic>
        <p:nvPicPr>
          <p:cNvPr id="30" name="Image 29">
            <a:extLst>
              <a:ext uri="{FF2B5EF4-FFF2-40B4-BE49-F238E27FC236}">
                <a16:creationId xmlns:a16="http://schemas.microsoft.com/office/drawing/2014/main" id="{8BF5A36F-8A9D-8535-AC86-16EA814717C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0093" t="19182" r="25901" b="60162"/>
          <a:stretch/>
        </p:blipFill>
        <p:spPr>
          <a:xfrm>
            <a:off x="7069873" y="1755058"/>
            <a:ext cx="4138598" cy="1357568"/>
          </a:xfrm>
          <a:prstGeom prst="rect">
            <a:avLst/>
          </a:prstGeom>
        </p:spPr>
      </p:pic>
      <p:grpSp>
        <p:nvGrpSpPr>
          <p:cNvPr id="31" name="Groupe 30">
            <a:extLst>
              <a:ext uri="{FF2B5EF4-FFF2-40B4-BE49-F238E27FC236}">
                <a16:creationId xmlns:a16="http://schemas.microsoft.com/office/drawing/2014/main" id="{C04FD067-1368-3A44-18D9-7E0C6006D550}"/>
              </a:ext>
            </a:extLst>
          </p:cNvPr>
          <p:cNvGrpSpPr/>
          <p:nvPr/>
        </p:nvGrpSpPr>
        <p:grpSpPr>
          <a:xfrm>
            <a:off x="7263702" y="367713"/>
            <a:ext cx="3777039" cy="1364974"/>
            <a:chOff x="1557995" y="839779"/>
            <a:chExt cx="3777039" cy="1364974"/>
          </a:xfrm>
        </p:grpSpPr>
        <p:sp>
          <p:nvSpPr>
            <p:cNvPr id="32" name="ZoneTexte 31">
              <a:extLst>
                <a:ext uri="{FF2B5EF4-FFF2-40B4-BE49-F238E27FC236}">
                  <a16:creationId xmlns:a16="http://schemas.microsoft.com/office/drawing/2014/main" id="{1C268793-F789-5419-3A31-E55EB0C88722}"/>
                </a:ext>
              </a:extLst>
            </p:cNvPr>
            <p:cNvSpPr txBox="1"/>
            <p:nvPr/>
          </p:nvSpPr>
          <p:spPr>
            <a:xfrm rot="16200000">
              <a:off x="1060174" y="1337600"/>
              <a:ext cx="13649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/>
                <a:t>SHAM 1 </a:t>
              </a:r>
            </a:p>
          </p:txBody>
        </p:sp>
        <p:sp>
          <p:nvSpPr>
            <p:cNvPr id="33" name="ZoneTexte 32">
              <a:extLst>
                <a:ext uri="{FF2B5EF4-FFF2-40B4-BE49-F238E27FC236}">
                  <a16:creationId xmlns:a16="http://schemas.microsoft.com/office/drawing/2014/main" id="{2D78000D-3061-3767-7B9B-5C8814251323}"/>
                </a:ext>
              </a:extLst>
            </p:cNvPr>
            <p:cNvSpPr txBox="1"/>
            <p:nvPr/>
          </p:nvSpPr>
          <p:spPr>
            <a:xfrm rot="16200000">
              <a:off x="1311100" y="1337600"/>
              <a:ext cx="13649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/>
                <a:t>SHAM 2 </a:t>
              </a:r>
            </a:p>
          </p:txBody>
        </p:sp>
        <p:sp>
          <p:nvSpPr>
            <p:cNvPr id="34" name="ZoneTexte 33">
              <a:extLst>
                <a:ext uri="{FF2B5EF4-FFF2-40B4-BE49-F238E27FC236}">
                  <a16:creationId xmlns:a16="http://schemas.microsoft.com/office/drawing/2014/main" id="{E9D1748D-8858-397A-C680-BB2901C8EBC4}"/>
                </a:ext>
              </a:extLst>
            </p:cNvPr>
            <p:cNvSpPr txBox="1"/>
            <p:nvPr/>
          </p:nvSpPr>
          <p:spPr>
            <a:xfrm rot="16200000">
              <a:off x="1584343" y="1337600"/>
              <a:ext cx="13649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/>
                <a:t>LPS 1 </a:t>
              </a:r>
            </a:p>
          </p:txBody>
        </p:sp>
        <p:sp>
          <p:nvSpPr>
            <p:cNvPr id="35" name="ZoneTexte 34">
              <a:extLst>
                <a:ext uri="{FF2B5EF4-FFF2-40B4-BE49-F238E27FC236}">
                  <a16:creationId xmlns:a16="http://schemas.microsoft.com/office/drawing/2014/main" id="{95745284-9D9B-B386-95F5-CE7E88428955}"/>
                </a:ext>
              </a:extLst>
            </p:cNvPr>
            <p:cNvSpPr txBox="1"/>
            <p:nvPr/>
          </p:nvSpPr>
          <p:spPr>
            <a:xfrm rot="16200000">
              <a:off x="1852533" y="1337600"/>
              <a:ext cx="13649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/>
                <a:t>LPS 2 </a:t>
              </a:r>
            </a:p>
          </p:txBody>
        </p:sp>
        <p:sp>
          <p:nvSpPr>
            <p:cNvPr id="36" name="ZoneTexte 35">
              <a:extLst>
                <a:ext uri="{FF2B5EF4-FFF2-40B4-BE49-F238E27FC236}">
                  <a16:creationId xmlns:a16="http://schemas.microsoft.com/office/drawing/2014/main" id="{09D74D37-EF0B-08FC-29AC-EEBE2A4F74D6}"/>
                </a:ext>
              </a:extLst>
            </p:cNvPr>
            <p:cNvSpPr txBox="1"/>
            <p:nvPr/>
          </p:nvSpPr>
          <p:spPr>
            <a:xfrm rot="16200000">
              <a:off x="2108512" y="1337600"/>
              <a:ext cx="13649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/>
                <a:t>HSJ633 1-2H</a:t>
              </a:r>
            </a:p>
          </p:txBody>
        </p:sp>
        <p:sp>
          <p:nvSpPr>
            <p:cNvPr id="37" name="ZoneTexte 36">
              <a:extLst>
                <a:ext uri="{FF2B5EF4-FFF2-40B4-BE49-F238E27FC236}">
                  <a16:creationId xmlns:a16="http://schemas.microsoft.com/office/drawing/2014/main" id="{6C6CA2BD-55EF-C7A1-60C1-14D1E9BDD11B}"/>
                </a:ext>
              </a:extLst>
            </p:cNvPr>
            <p:cNvSpPr txBox="1"/>
            <p:nvPr/>
          </p:nvSpPr>
          <p:spPr>
            <a:xfrm rot="16200000">
              <a:off x="2364491" y="1337600"/>
              <a:ext cx="13649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/>
                <a:t>HSJ633 2-2H</a:t>
              </a:r>
            </a:p>
          </p:txBody>
        </p:sp>
        <p:sp>
          <p:nvSpPr>
            <p:cNvPr id="38" name="ZoneTexte 37">
              <a:extLst>
                <a:ext uri="{FF2B5EF4-FFF2-40B4-BE49-F238E27FC236}">
                  <a16:creationId xmlns:a16="http://schemas.microsoft.com/office/drawing/2014/main" id="{D3DE8760-3F73-3772-F349-0B64E08E3CEF}"/>
                </a:ext>
              </a:extLst>
            </p:cNvPr>
            <p:cNvSpPr txBox="1"/>
            <p:nvPr/>
          </p:nvSpPr>
          <p:spPr>
            <a:xfrm rot="16200000">
              <a:off x="2879438" y="1337600"/>
              <a:ext cx="13649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/>
                <a:t>SHAM 1</a:t>
              </a:r>
            </a:p>
          </p:txBody>
        </p:sp>
        <p:sp>
          <p:nvSpPr>
            <p:cNvPr id="39" name="ZoneTexte 38">
              <a:extLst>
                <a:ext uri="{FF2B5EF4-FFF2-40B4-BE49-F238E27FC236}">
                  <a16:creationId xmlns:a16="http://schemas.microsoft.com/office/drawing/2014/main" id="{A594E9F2-3440-6966-C957-936E6DA7BE84}"/>
                </a:ext>
              </a:extLst>
            </p:cNvPr>
            <p:cNvSpPr txBox="1"/>
            <p:nvPr/>
          </p:nvSpPr>
          <p:spPr>
            <a:xfrm rot="16200000">
              <a:off x="3152514" y="1337600"/>
              <a:ext cx="13649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/>
                <a:t>LPS 3 </a:t>
              </a:r>
            </a:p>
          </p:txBody>
        </p:sp>
        <p:sp>
          <p:nvSpPr>
            <p:cNvPr id="40" name="ZoneTexte 39">
              <a:extLst>
                <a:ext uri="{FF2B5EF4-FFF2-40B4-BE49-F238E27FC236}">
                  <a16:creationId xmlns:a16="http://schemas.microsoft.com/office/drawing/2014/main" id="{326EC876-A24C-8866-EB5D-0F74B127C807}"/>
                </a:ext>
              </a:extLst>
            </p:cNvPr>
            <p:cNvSpPr txBox="1"/>
            <p:nvPr/>
          </p:nvSpPr>
          <p:spPr>
            <a:xfrm rot="16200000">
              <a:off x="3394386" y="1337600"/>
              <a:ext cx="13649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/>
                <a:t>LPS 4</a:t>
              </a:r>
            </a:p>
          </p:txBody>
        </p:sp>
        <p:sp>
          <p:nvSpPr>
            <p:cNvPr id="41" name="ZoneTexte 40">
              <a:extLst>
                <a:ext uri="{FF2B5EF4-FFF2-40B4-BE49-F238E27FC236}">
                  <a16:creationId xmlns:a16="http://schemas.microsoft.com/office/drawing/2014/main" id="{367F7FCA-5B75-940D-7504-F3C3A7731B9D}"/>
                </a:ext>
              </a:extLst>
            </p:cNvPr>
            <p:cNvSpPr txBox="1"/>
            <p:nvPr/>
          </p:nvSpPr>
          <p:spPr>
            <a:xfrm rot="16200000">
              <a:off x="3636258" y="1337600"/>
              <a:ext cx="13649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/>
                <a:t>LPS 5</a:t>
              </a:r>
            </a:p>
          </p:txBody>
        </p:sp>
        <p:sp>
          <p:nvSpPr>
            <p:cNvPr id="42" name="ZoneTexte 41">
              <a:extLst>
                <a:ext uri="{FF2B5EF4-FFF2-40B4-BE49-F238E27FC236}">
                  <a16:creationId xmlns:a16="http://schemas.microsoft.com/office/drawing/2014/main" id="{47EFA8B9-C22F-82BE-960F-27E038139867}"/>
                </a:ext>
              </a:extLst>
            </p:cNvPr>
            <p:cNvSpPr txBox="1"/>
            <p:nvPr/>
          </p:nvSpPr>
          <p:spPr>
            <a:xfrm rot="16200000">
              <a:off x="3943712" y="1337600"/>
              <a:ext cx="13649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/>
                <a:t>HSJ633 3-2H</a:t>
              </a:r>
            </a:p>
          </p:txBody>
        </p:sp>
        <p:sp>
          <p:nvSpPr>
            <p:cNvPr id="43" name="ZoneTexte 42">
              <a:extLst>
                <a:ext uri="{FF2B5EF4-FFF2-40B4-BE49-F238E27FC236}">
                  <a16:creationId xmlns:a16="http://schemas.microsoft.com/office/drawing/2014/main" id="{ACE04103-BD62-957A-3309-3C901EE04774}"/>
                </a:ext>
              </a:extLst>
            </p:cNvPr>
            <p:cNvSpPr txBox="1"/>
            <p:nvPr/>
          </p:nvSpPr>
          <p:spPr>
            <a:xfrm rot="16200000">
              <a:off x="4194638" y="1337600"/>
              <a:ext cx="13649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/>
                <a:t>HSJ633 4-2H</a:t>
              </a:r>
            </a:p>
          </p:txBody>
        </p:sp>
        <p:sp>
          <p:nvSpPr>
            <p:cNvPr id="44" name="ZoneTexte 43">
              <a:extLst>
                <a:ext uri="{FF2B5EF4-FFF2-40B4-BE49-F238E27FC236}">
                  <a16:creationId xmlns:a16="http://schemas.microsoft.com/office/drawing/2014/main" id="{C62F2F21-A614-2932-94F3-AE4E13BCB4FF}"/>
                </a:ext>
              </a:extLst>
            </p:cNvPr>
            <p:cNvSpPr txBox="1"/>
            <p:nvPr/>
          </p:nvSpPr>
          <p:spPr>
            <a:xfrm rot="16200000">
              <a:off x="4467881" y="1337600"/>
              <a:ext cx="13649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/>
                <a:t>HSJ633 5-2H</a:t>
              </a:r>
            </a:p>
          </p:txBody>
        </p:sp>
      </p:grpSp>
      <p:sp>
        <p:nvSpPr>
          <p:cNvPr id="46" name="ZoneTexte 45">
            <a:extLst>
              <a:ext uri="{FF2B5EF4-FFF2-40B4-BE49-F238E27FC236}">
                <a16:creationId xmlns:a16="http://schemas.microsoft.com/office/drawing/2014/main" id="{EBD16E46-9C0A-7D2C-F940-C018AC6FFF09}"/>
              </a:ext>
            </a:extLst>
          </p:cNvPr>
          <p:cNvSpPr txBox="1"/>
          <p:nvPr/>
        </p:nvSpPr>
        <p:spPr>
          <a:xfrm>
            <a:off x="5880299" y="2034279"/>
            <a:ext cx="14585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t-STAT3</a:t>
            </a:r>
          </a:p>
        </p:txBody>
      </p:sp>
      <p:grpSp>
        <p:nvGrpSpPr>
          <p:cNvPr id="3" name="Groupe 2">
            <a:extLst>
              <a:ext uri="{FF2B5EF4-FFF2-40B4-BE49-F238E27FC236}">
                <a16:creationId xmlns:a16="http://schemas.microsoft.com/office/drawing/2014/main" id="{9D58B503-C2FC-817B-6769-C91F8A465AF2}"/>
              </a:ext>
            </a:extLst>
          </p:cNvPr>
          <p:cNvGrpSpPr/>
          <p:nvPr/>
        </p:nvGrpSpPr>
        <p:grpSpPr>
          <a:xfrm>
            <a:off x="1008732" y="1296069"/>
            <a:ext cx="787289" cy="1585395"/>
            <a:chOff x="1487835" y="1659100"/>
            <a:chExt cx="787289" cy="1585395"/>
          </a:xfrm>
        </p:grpSpPr>
        <p:sp>
          <p:nvSpPr>
            <p:cNvPr id="4" name="ZoneTexte 3">
              <a:extLst>
                <a:ext uri="{FF2B5EF4-FFF2-40B4-BE49-F238E27FC236}">
                  <a16:creationId xmlns:a16="http://schemas.microsoft.com/office/drawing/2014/main" id="{529738F4-6F37-5FC5-C736-0BE87B52F4C3}"/>
                </a:ext>
              </a:extLst>
            </p:cNvPr>
            <p:cNvSpPr txBox="1"/>
            <p:nvPr/>
          </p:nvSpPr>
          <p:spPr>
            <a:xfrm>
              <a:off x="1546254" y="2470448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75</a:t>
              </a:r>
            </a:p>
          </p:txBody>
        </p:sp>
        <p:sp>
          <p:nvSpPr>
            <p:cNvPr id="5" name="ZoneTexte 4">
              <a:extLst>
                <a:ext uri="{FF2B5EF4-FFF2-40B4-BE49-F238E27FC236}">
                  <a16:creationId xmlns:a16="http://schemas.microsoft.com/office/drawing/2014/main" id="{0578BC3D-32C4-1488-6F67-998FE946AEBF}"/>
                </a:ext>
              </a:extLst>
            </p:cNvPr>
            <p:cNvSpPr txBox="1"/>
            <p:nvPr/>
          </p:nvSpPr>
          <p:spPr>
            <a:xfrm>
              <a:off x="1535103" y="2730771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50</a:t>
              </a:r>
            </a:p>
          </p:txBody>
        </p:sp>
        <p:sp>
          <p:nvSpPr>
            <p:cNvPr id="6" name="ZoneTexte 5">
              <a:extLst>
                <a:ext uri="{FF2B5EF4-FFF2-40B4-BE49-F238E27FC236}">
                  <a16:creationId xmlns:a16="http://schemas.microsoft.com/office/drawing/2014/main" id="{3653EFAC-4426-B876-0058-9512AD27D1AD}"/>
                </a:ext>
              </a:extLst>
            </p:cNvPr>
            <p:cNvSpPr txBox="1"/>
            <p:nvPr/>
          </p:nvSpPr>
          <p:spPr>
            <a:xfrm>
              <a:off x="1546254" y="2967496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37</a:t>
              </a:r>
            </a:p>
          </p:txBody>
        </p:sp>
        <p:sp>
          <p:nvSpPr>
            <p:cNvPr id="7" name="ZoneTexte 6">
              <a:extLst>
                <a:ext uri="{FF2B5EF4-FFF2-40B4-BE49-F238E27FC236}">
                  <a16:creationId xmlns:a16="http://schemas.microsoft.com/office/drawing/2014/main" id="{E92F9BE9-207B-7E02-0321-D74A09A60F0F}"/>
                </a:ext>
              </a:extLst>
            </p:cNvPr>
            <p:cNvSpPr txBox="1"/>
            <p:nvPr/>
          </p:nvSpPr>
          <p:spPr>
            <a:xfrm>
              <a:off x="1487835" y="2147805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150</a:t>
              </a:r>
            </a:p>
          </p:txBody>
        </p:sp>
        <p:sp>
          <p:nvSpPr>
            <p:cNvPr id="8" name="ZoneTexte 7">
              <a:extLst>
                <a:ext uri="{FF2B5EF4-FFF2-40B4-BE49-F238E27FC236}">
                  <a16:creationId xmlns:a16="http://schemas.microsoft.com/office/drawing/2014/main" id="{38AE9F36-2700-EB87-42A6-1B76520887A0}"/>
                </a:ext>
              </a:extLst>
            </p:cNvPr>
            <p:cNvSpPr txBox="1"/>
            <p:nvPr/>
          </p:nvSpPr>
          <p:spPr>
            <a:xfrm>
              <a:off x="1487835" y="2298471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100</a:t>
              </a:r>
            </a:p>
          </p:txBody>
        </p:sp>
        <p:sp>
          <p:nvSpPr>
            <p:cNvPr id="29" name="ZoneTexte 28">
              <a:extLst>
                <a:ext uri="{FF2B5EF4-FFF2-40B4-BE49-F238E27FC236}">
                  <a16:creationId xmlns:a16="http://schemas.microsoft.com/office/drawing/2014/main" id="{A7C4E4F8-8EFB-4B75-1219-0807156CE795}"/>
                </a:ext>
              </a:extLst>
            </p:cNvPr>
            <p:cNvSpPr txBox="1"/>
            <p:nvPr/>
          </p:nvSpPr>
          <p:spPr>
            <a:xfrm>
              <a:off x="1503915" y="2000932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250</a:t>
              </a:r>
            </a:p>
          </p:txBody>
        </p:sp>
        <p:sp>
          <p:nvSpPr>
            <p:cNvPr id="47" name="ZoneTexte 46">
              <a:extLst>
                <a:ext uri="{FF2B5EF4-FFF2-40B4-BE49-F238E27FC236}">
                  <a16:creationId xmlns:a16="http://schemas.microsoft.com/office/drawing/2014/main" id="{C1616ADC-37C0-3541-0E5C-F6C3736A25BA}"/>
                </a:ext>
              </a:extLst>
            </p:cNvPr>
            <p:cNvSpPr txBox="1"/>
            <p:nvPr/>
          </p:nvSpPr>
          <p:spPr>
            <a:xfrm>
              <a:off x="1487835" y="1659100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err="1"/>
                <a:t>kDa</a:t>
              </a:r>
              <a:endParaRPr lang="en-CA" sz="1200" dirty="0"/>
            </a:p>
          </p:txBody>
        </p:sp>
      </p:grpSp>
      <p:grpSp>
        <p:nvGrpSpPr>
          <p:cNvPr id="48" name="Groupe 47">
            <a:extLst>
              <a:ext uri="{FF2B5EF4-FFF2-40B4-BE49-F238E27FC236}">
                <a16:creationId xmlns:a16="http://schemas.microsoft.com/office/drawing/2014/main" id="{33C0E017-7FE6-85A8-9D05-0BC279E3B1CE}"/>
              </a:ext>
            </a:extLst>
          </p:cNvPr>
          <p:cNvGrpSpPr/>
          <p:nvPr/>
        </p:nvGrpSpPr>
        <p:grpSpPr>
          <a:xfrm>
            <a:off x="6724441" y="1411977"/>
            <a:ext cx="787289" cy="1574244"/>
            <a:chOff x="1487835" y="1659100"/>
            <a:chExt cx="787289" cy="1574244"/>
          </a:xfrm>
        </p:grpSpPr>
        <p:sp>
          <p:nvSpPr>
            <p:cNvPr id="49" name="ZoneTexte 48">
              <a:extLst>
                <a:ext uri="{FF2B5EF4-FFF2-40B4-BE49-F238E27FC236}">
                  <a16:creationId xmlns:a16="http://schemas.microsoft.com/office/drawing/2014/main" id="{6363D17E-B83F-48EB-4E8F-2903CEEF65EC}"/>
                </a:ext>
              </a:extLst>
            </p:cNvPr>
            <p:cNvSpPr txBox="1"/>
            <p:nvPr/>
          </p:nvSpPr>
          <p:spPr>
            <a:xfrm>
              <a:off x="1546254" y="2470448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75</a:t>
              </a:r>
            </a:p>
          </p:txBody>
        </p:sp>
        <p:sp>
          <p:nvSpPr>
            <p:cNvPr id="50" name="ZoneTexte 49">
              <a:extLst>
                <a:ext uri="{FF2B5EF4-FFF2-40B4-BE49-F238E27FC236}">
                  <a16:creationId xmlns:a16="http://schemas.microsoft.com/office/drawing/2014/main" id="{65B2A4C9-CE6E-AC8F-AADC-860673BA72C7}"/>
                </a:ext>
              </a:extLst>
            </p:cNvPr>
            <p:cNvSpPr txBox="1"/>
            <p:nvPr/>
          </p:nvSpPr>
          <p:spPr>
            <a:xfrm>
              <a:off x="1535103" y="2741922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50</a:t>
              </a:r>
            </a:p>
          </p:txBody>
        </p:sp>
        <p:sp>
          <p:nvSpPr>
            <p:cNvPr id="51" name="ZoneTexte 50">
              <a:extLst>
                <a:ext uri="{FF2B5EF4-FFF2-40B4-BE49-F238E27FC236}">
                  <a16:creationId xmlns:a16="http://schemas.microsoft.com/office/drawing/2014/main" id="{8B40605A-B9AE-0395-8F39-76EB43A5AE29}"/>
                </a:ext>
              </a:extLst>
            </p:cNvPr>
            <p:cNvSpPr txBox="1"/>
            <p:nvPr/>
          </p:nvSpPr>
          <p:spPr>
            <a:xfrm>
              <a:off x="1546254" y="2956345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37</a:t>
              </a:r>
            </a:p>
          </p:txBody>
        </p:sp>
        <p:sp>
          <p:nvSpPr>
            <p:cNvPr id="52" name="ZoneTexte 51">
              <a:extLst>
                <a:ext uri="{FF2B5EF4-FFF2-40B4-BE49-F238E27FC236}">
                  <a16:creationId xmlns:a16="http://schemas.microsoft.com/office/drawing/2014/main" id="{69CFA66B-9683-741C-AB50-69E998DF3544}"/>
                </a:ext>
              </a:extLst>
            </p:cNvPr>
            <p:cNvSpPr txBox="1"/>
            <p:nvPr/>
          </p:nvSpPr>
          <p:spPr>
            <a:xfrm>
              <a:off x="1487835" y="2147805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150</a:t>
              </a:r>
            </a:p>
          </p:txBody>
        </p:sp>
        <p:sp>
          <p:nvSpPr>
            <p:cNvPr id="53" name="ZoneTexte 52">
              <a:extLst>
                <a:ext uri="{FF2B5EF4-FFF2-40B4-BE49-F238E27FC236}">
                  <a16:creationId xmlns:a16="http://schemas.microsoft.com/office/drawing/2014/main" id="{337AF457-0E00-F1DB-230C-032D013D5E04}"/>
                </a:ext>
              </a:extLst>
            </p:cNvPr>
            <p:cNvSpPr txBox="1"/>
            <p:nvPr/>
          </p:nvSpPr>
          <p:spPr>
            <a:xfrm>
              <a:off x="1487835" y="2298471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100</a:t>
              </a:r>
            </a:p>
          </p:txBody>
        </p:sp>
        <p:sp>
          <p:nvSpPr>
            <p:cNvPr id="54" name="ZoneTexte 53">
              <a:extLst>
                <a:ext uri="{FF2B5EF4-FFF2-40B4-BE49-F238E27FC236}">
                  <a16:creationId xmlns:a16="http://schemas.microsoft.com/office/drawing/2014/main" id="{BD074344-B877-4A79-08CD-34FE6A7284B7}"/>
                </a:ext>
              </a:extLst>
            </p:cNvPr>
            <p:cNvSpPr txBox="1"/>
            <p:nvPr/>
          </p:nvSpPr>
          <p:spPr>
            <a:xfrm>
              <a:off x="1503915" y="2000932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250</a:t>
              </a:r>
            </a:p>
          </p:txBody>
        </p:sp>
        <p:sp>
          <p:nvSpPr>
            <p:cNvPr id="55" name="ZoneTexte 54">
              <a:extLst>
                <a:ext uri="{FF2B5EF4-FFF2-40B4-BE49-F238E27FC236}">
                  <a16:creationId xmlns:a16="http://schemas.microsoft.com/office/drawing/2014/main" id="{88B17978-015D-7FF8-9116-C64E1166628F}"/>
                </a:ext>
              </a:extLst>
            </p:cNvPr>
            <p:cNvSpPr txBox="1"/>
            <p:nvPr/>
          </p:nvSpPr>
          <p:spPr>
            <a:xfrm>
              <a:off x="1487835" y="1659100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err="1"/>
                <a:t>kDa</a:t>
              </a:r>
              <a:endParaRPr lang="en-CA" sz="1200" dirty="0"/>
            </a:p>
          </p:txBody>
        </p:sp>
      </p:grpSp>
      <p:sp>
        <p:nvSpPr>
          <p:cNvPr id="56" name="Rectangle 55">
            <a:extLst>
              <a:ext uri="{FF2B5EF4-FFF2-40B4-BE49-F238E27FC236}">
                <a16:creationId xmlns:a16="http://schemas.microsoft.com/office/drawing/2014/main" id="{F1A78F1A-6D98-99DB-96FC-84C24DB1C8D8}"/>
              </a:ext>
            </a:extLst>
          </p:cNvPr>
          <p:cNvSpPr/>
          <p:nvPr/>
        </p:nvSpPr>
        <p:spPr>
          <a:xfrm>
            <a:off x="1603534" y="2039471"/>
            <a:ext cx="1628110" cy="305967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2F99FEBD-D1FF-46FB-F835-6B80AC8D1B0D}"/>
              </a:ext>
            </a:extLst>
          </p:cNvPr>
          <p:cNvSpPr/>
          <p:nvPr/>
        </p:nvSpPr>
        <p:spPr>
          <a:xfrm>
            <a:off x="7283795" y="2126829"/>
            <a:ext cx="1628110" cy="305967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grpSp>
        <p:nvGrpSpPr>
          <p:cNvPr id="58" name="Groupe 57">
            <a:extLst>
              <a:ext uri="{FF2B5EF4-FFF2-40B4-BE49-F238E27FC236}">
                <a16:creationId xmlns:a16="http://schemas.microsoft.com/office/drawing/2014/main" id="{EF27F0BE-3B6D-59AE-C2E8-A356A75DB465}"/>
              </a:ext>
            </a:extLst>
          </p:cNvPr>
          <p:cNvGrpSpPr/>
          <p:nvPr/>
        </p:nvGrpSpPr>
        <p:grpSpPr>
          <a:xfrm>
            <a:off x="5407188" y="4910944"/>
            <a:ext cx="3085939" cy="1070157"/>
            <a:chOff x="6332418" y="4309293"/>
            <a:chExt cx="3085939" cy="1070157"/>
          </a:xfrm>
        </p:grpSpPr>
        <p:sp>
          <p:nvSpPr>
            <p:cNvPr id="59" name="ZoneTexte 58">
              <a:extLst>
                <a:ext uri="{FF2B5EF4-FFF2-40B4-BE49-F238E27FC236}">
                  <a16:creationId xmlns:a16="http://schemas.microsoft.com/office/drawing/2014/main" id="{9FB985A4-9185-58B3-A9A4-393B676E96BE}"/>
                </a:ext>
              </a:extLst>
            </p:cNvPr>
            <p:cNvSpPr txBox="1"/>
            <p:nvPr/>
          </p:nvSpPr>
          <p:spPr>
            <a:xfrm>
              <a:off x="7498062" y="4565444"/>
              <a:ext cx="6973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ehicle</a:t>
              </a:r>
              <a:r>
                <a:rPr lang="en-CA" sz="1200" dirty="0"/>
                <a:t> </a:t>
              </a:r>
            </a:p>
          </p:txBody>
        </p:sp>
        <p:grpSp>
          <p:nvGrpSpPr>
            <p:cNvPr id="60" name="Groupe 59">
              <a:extLst>
                <a:ext uri="{FF2B5EF4-FFF2-40B4-BE49-F238E27FC236}">
                  <a16:creationId xmlns:a16="http://schemas.microsoft.com/office/drawing/2014/main" id="{B6339AAA-34CB-60F4-5E3A-F3BF82BBB6B7}"/>
                </a:ext>
              </a:extLst>
            </p:cNvPr>
            <p:cNvGrpSpPr/>
            <p:nvPr/>
          </p:nvGrpSpPr>
          <p:grpSpPr>
            <a:xfrm>
              <a:off x="6332418" y="4309293"/>
              <a:ext cx="3085939" cy="1070157"/>
              <a:chOff x="6332418" y="4309293"/>
              <a:chExt cx="3085939" cy="1070157"/>
            </a:xfrm>
          </p:grpSpPr>
          <p:grpSp>
            <p:nvGrpSpPr>
              <p:cNvPr id="61" name="Groupe 60">
                <a:extLst>
                  <a:ext uri="{FF2B5EF4-FFF2-40B4-BE49-F238E27FC236}">
                    <a16:creationId xmlns:a16="http://schemas.microsoft.com/office/drawing/2014/main" id="{0D20983A-9EAB-F47F-CEEB-396422CBAB25}"/>
                  </a:ext>
                </a:extLst>
              </p:cNvPr>
              <p:cNvGrpSpPr/>
              <p:nvPr/>
            </p:nvGrpSpPr>
            <p:grpSpPr>
              <a:xfrm>
                <a:off x="6332418" y="4309293"/>
                <a:ext cx="3085939" cy="1070157"/>
                <a:chOff x="1692699" y="1026067"/>
                <a:chExt cx="3085939" cy="1070157"/>
              </a:xfrm>
            </p:grpSpPr>
            <p:pic>
              <p:nvPicPr>
                <p:cNvPr id="63" name="Image 62">
                  <a:extLst>
                    <a:ext uri="{FF2B5EF4-FFF2-40B4-BE49-F238E27FC236}">
                      <a16:creationId xmlns:a16="http://schemas.microsoft.com/office/drawing/2014/main" id="{857A64D8-CC78-A275-1063-AD2F6B1C863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37035" t="17736" r="44141" b="78557"/>
                <a:stretch/>
              </p:blipFill>
              <p:spPr>
                <a:xfrm>
                  <a:off x="2385391" y="1510748"/>
                  <a:ext cx="1643269" cy="238539"/>
                </a:xfrm>
                <a:prstGeom prst="rect">
                  <a:avLst/>
                </a:prstGeom>
                <a:ln w="12700">
                  <a:solidFill>
                    <a:schemeClr val="tx1"/>
                  </a:solidFill>
                </a:ln>
              </p:spPr>
            </p:pic>
            <p:pic>
              <p:nvPicPr>
                <p:cNvPr id="64" name="Image 63">
                  <a:extLst>
                    <a:ext uri="{FF2B5EF4-FFF2-40B4-BE49-F238E27FC236}">
                      <a16:creationId xmlns:a16="http://schemas.microsoft.com/office/drawing/2014/main" id="{1719A5FC-E16D-4DCA-5D80-0B9AEDF09EF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32390" t="25295" r="50138" b="71076"/>
                <a:stretch/>
              </p:blipFill>
              <p:spPr>
                <a:xfrm>
                  <a:off x="2385391" y="1851991"/>
                  <a:ext cx="1643270" cy="238540"/>
                </a:xfrm>
                <a:prstGeom prst="rect">
                  <a:avLst/>
                </a:prstGeom>
                <a:ln w="12700">
                  <a:solidFill>
                    <a:schemeClr val="tx1"/>
                  </a:solidFill>
                </a:ln>
              </p:spPr>
            </p:pic>
            <p:sp>
              <p:nvSpPr>
                <p:cNvPr id="65" name="ZoneTexte 64">
                  <a:extLst>
                    <a:ext uri="{FF2B5EF4-FFF2-40B4-BE49-F238E27FC236}">
                      <a16:creationId xmlns:a16="http://schemas.microsoft.com/office/drawing/2014/main" id="{7C45461E-4CC2-0A05-2FE6-57C896FE5F9B}"/>
                    </a:ext>
                  </a:extLst>
                </p:cNvPr>
                <p:cNvSpPr txBox="1"/>
                <p:nvPr/>
              </p:nvSpPr>
              <p:spPr>
                <a:xfrm>
                  <a:off x="2326862" y="1276525"/>
                  <a:ext cx="88016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ham  </a:t>
                  </a:r>
                </a:p>
              </p:txBody>
            </p:sp>
            <p:sp>
              <p:nvSpPr>
                <p:cNvPr id="66" name="ZoneTexte 65">
                  <a:extLst>
                    <a:ext uri="{FF2B5EF4-FFF2-40B4-BE49-F238E27FC236}">
                      <a16:creationId xmlns:a16="http://schemas.microsoft.com/office/drawing/2014/main" id="{6519FB8D-AF75-394A-91DC-29E44EEAD9BD}"/>
                    </a:ext>
                  </a:extLst>
                </p:cNvPr>
                <p:cNvSpPr txBox="1"/>
                <p:nvPr/>
              </p:nvSpPr>
              <p:spPr>
                <a:xfrm>
                  <a:off x="3267614" y="1026067"/>
                  <a:ext cx="53731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LPS </a:t>
                  </a:r>
                </a:p>
              </p:txBody>
            </p:sp>
            <p:sp>
              <p:nvSpPr>
                <p:cNvPr id="67" name="ZoneTexte 66">
                  <a:extLst>
                    <a:ext uri="{FF2B5EF4-FFF2-40B4-BE49-F238E27FC236}">
                      <a16:creationId xmlns:a16="http://schemas.microsoft.com/office/drawing/2014/main" id="{962D0158-56D1-8BF4-16D9-E339D03BB773}"/>
                    </a:ext>
                  </a:extLst>
                </p:cNvPr>
                <p:cNvSpPr txBox="1"/>
                <p:nvPr/>
              </p:nvSpPr>
              <p:spPr>
                <a:xfrm>
                  <a:off x="3469854" y="1279189"/>
                  <a:ext cx="130878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SJ633-2h</a:t>
                  </a:r>
                </a:p>
              </p:txBody>
            </p:sp>
            <p:sp>
              <p:nvSpPr>
                <p:cNvPr id="68" name="ZoneTexte 67">
                  <a:extLst>
                    <a:ext uri="{FF2B5EF4-FFF2-40B4-BE49-F238E27FC236}">
                      <a16:creationId xmlns:a16="http://schemas.microsoft.com/office/drawing/2014/main" id="{882E04E9-9F05-1583-2CE8-EFFCB3200DE8}"/>
                    </a:ext>
                  </a:extLst>
                </p:cNvPr>
                <p:cNvSpPr txBox="1"/>
                <p:nvPr/>
              </p:nvSpPr>
              <p:spPr>
                <a:xfrm>
                  <a:off x="1692699" y="1505705"/>
                  <a:ext cx="145857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-STAT3</a:t>
                  </a:r>
                </a:p>
              </p:txBody>
            </p:sp>
            <p:sp>
              <p:nvSpPr>
                <p:cNvPr id="69" name="ZoneTexte 68">
                  <a:extLst>
                    <a:ext uri="{FF2B5EF4-FFF2-40B4-BE49-F238E27FC236}">
                      <a16:creationId xmlns:a16="http://schemas.microsoft.com/office/drawing/2014/main" id="{215A6E62-6362-DFE2-E578-F3B51401DBF7}"/>
                    </a:ext>
                  </a:extLst>
                </p:cNvPr>
                <p:cNvSpPr txBox="1"/>
                <p:nvPr/>
              </p:nvSpPr>
              <p:spPr>
                <a:xfrm>
                  <a:off x="1692699" y="1819225"/>
                  <a:ext cx="145857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-STAT3</a:t>
                  </a:r>
                </a:p>
              </p:txBody>
            </p:sp>
          </p:grpSp>
          <p:cxnSp>
            <p:nvCxnSpPr>
              <p:cNvPr id="62" name="Connecteur droit 61">
                <a:extLst>
                  <a:ext uri="{FF2B5EF4-FFF2-40B4-BE49-F238E27FC236}">
                    <a16:creationId xmlns:a16="http://schemas.microsoft.com/office/drawing/2014/main" id="{38C6FBC0-1B30-391B-D65C-69C2A44D5264}"/>
                  </a:ext>
                </a:extLst>
              </p:cNvPr>
              <p:cNvCxnSpPr>
                <a:endCxn id="67" idx="0"/>
              </p:cNvCxnSpPr>
              <p:nvPr/>
            </p:nvCxnSpPr>
            <p:spPr>
              <a:xfrm>
                <a:off x="7498062" y="4559751"/>
                <a:ext cx="1265903" cy="2664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10199363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ZoneTexte 24">
            <a:extLst>
              <a:ext uri="{FF2B5EF4-FFF2-40B4-BE49-F238E27FC236}">
                <a16:creationId xmlns:a16="http://schemas.microsoft.com/office/drawing/2014/main" id="{74676D1E-42F3-D74F-4E0E-7529C36350AF}"/>
              </a:ext>
            </a:extLst>
          </p:cNvPr>
          <p:cNvSpPr txBox="1"/>
          <p:nvPr/>
        </p:nvSpPr>
        <p:spPr>
          <a:xfrm>
            <a:off x="287838" y="2481214"/>
            <a:ext cx="14585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p-STAT3</a:t>
            </a: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6FC70EF0-60E1-82A5-F6C1-5EB430020399}"/>
              </a:ext>
            </a:extLst>
          </p:cNvPr>
          <p:cNvSpPr txBox="1"/>
          <p:nvPr/>
        </p:nvSpPr>
        <p:spPr>
          <a:xfrm>
            <a:off x="278779" y="3657285"/>
            <a:ext cx="14585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COXIV</a:t>
            </a:r>
          </a:p>
        </p:txBody>
      </p:sp>
      <p:sp>
        <p:nvSpPr>
          <p:cNvPr id="46" name="ZoneTexte 45">
            <a:extLst>
              <a:ext uri="{FF2B5EF4-FFF2-40B4-BE49-F238E27FC236}">
                <a16:creationId xmlns:a16="http://schemas.microsoft.com/office/drawing/2014/main" id="{EBD16E46-9C0A-7D2C-F940-C018AC6FFF09}"/>
              </a:ext>
            </a:extLst>
          </p:cNvPr>
          <p:cNvSpPr txBox="1"/>
          <p:nvPr/>
        </p:nvSpPr>
        <p:spPr>
          <a:xfrm>
            <a:off x="7122229" y="2454841"/>
            <a:ext cx="14585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t-STAT3</a:t>
            </a:r>
          </a:p>
        </p:txBody>
      </p:sp>
      <p:grpSp>
        <p:nvGrpSpPr>
          <p:cNvPr id="6" name="Groupe 5">
            <a:extLst>
              <a:ext uri="{FF2B5EF4-FFF2-40B4-BE49-F238E27FC236}">
                <a16:creationId xmlns:a16="http://schemas.microsoft.com/office/drawing/2014/main" id="{A7C26531-4CD3-362C-AF05-2F7556CF2D41}"/>
              </a:ext>
            </a:extLst>
          </p:cNvPr>
          <p:cNvGrpSpPr/>
          <p:nvPr/>
        </p:nvGrpSpPr>
        <p:grpSpPr>
          <a:xfrm>
            <a:off x="1301096" y="-1271240"/>
            <a:ext cx="3202317" cy="3442539"/>
            <a:chOff x="1301096" y="-1271240"/>
            <a:chExt cx="3202317" cy="3442539"/>
          </a:xfrm>
        </p:grpSpPr>
        <p:sp>
          <p:nvSpPr>
            <p:cNvPr id="3" name="ZoneTexte 2">
              <a:extLst>
                <a:ext uri="{FF2B5EF4-FFF2-40B4-BE49-F238E27FC236}">
                  <a16:creationId xmlns:a16="http://schemas.microsoft.com/office/drawing/2014/main" id="{AD6888FD-2907-F567-AB07-6D16517CE23C}"/>
                </a:ext>
              </a:extLst>
            </p:cNvPr>
            <p:cNvSpPr txBox="1"/>
            <p:nvPr/>
          </p:nvSpPr>
          <p:spPr>
            <a:xfrm rot="16200000">
              <a:off x="2236181" y="912132"/>
              <a:ext cx="214900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/>
                <a:t>HSJ633 2-2H 16/10</a:t>
              </a:r>
            </a:p>
          </p:txBody>
        </p:sp>
        <p:grpSp>
          <p:nvGrpSpPr>
            <p:cNvPr id="5" name="Groupe 4">
              <a:extLst>
                <a:ext uri="{FF2B5EF4-FFF2-40B4-BE49-F238E27FC236}">
                  <a16:creationId xmlns:a16="http://schemas.microsoft.com/office/drawing/2014/main" id="{C8337435-EDD8-0B67-EA5A-9C240ED9A15C}"/>
                </a:ext>
              </a:extLst>
            </p:cNvPr>
            <p:cNvGrpSpPr/>
            <p:nvPr/>
          </p:nvGrpSpPr>
          <p:grpSpPr>
            <a:xfrm>
              <a:off x="1301096" y="-1271240"/>
              <a:ext cx="3202317" cy="3442539"/>
              <a:chOff x="1301096" y="-1271240"/>
              <a:chExt cx="3202317" cy="3442539"/>
            </a:xfrm>
          </p:grpSpPr>
          <p:grpSp>
            <p:nvGrpSpPr>
              <p:cNvPr id="23" name="Groupe 22">
                <a:extLst>
                  <a:ext uri="{FF2B5EF4-FFF2-40B4-BE49-F238E27FC236}">
                    <a16:creationId xmlns:a16="http://schemas.microsoft.com/office/drawing/2014/main" id="{DC67F4C3-DBAE-801A-4A5D-DE50F4747221}"/>
                  </a:ext>
                </a:extLst>
              </p:cNvPr>
              <p:cNvGrpSpPr/>
              <p:nvPr/>
            </p:nvGrpSpPr>
            <p:grpSpPr>
              <a:xfrm>
                <a:off x="1557996" y="-1271240"/>
                <a:ext cx="2945417" cy="3442539"/>
                <a:chOff x="1557996" y="-1237786"/>
                <a:chExt cx="2945417" cy="3442539"/>
              </a:xfrm>
            </p:grpSpPr>
            <p:sp>
              <p:nvSpPr>
                <p:cNvPr id="10" name="ZoneTexte 9">
                  <a:extLst>
                    <a:ext uri="{FF2B5EF4-FFF2-40B4-BE49-F238E27FC236}">
                      <a16:creationId xmlns:a16="http://schemas.microsoft.com/office/drawing/2014/main" id="{433129C9-FDC8-A050-11AC-4CCE46060890}"/>
                    </a:ext>
                  </a:extLst>
                </p:cNvPr>
                <p:cNvSpPr txBox="1"/>
                <p:nvPr/>
              </p:nvSpPr>
              <p:spPr>
                <a:xfrm rot="16200000">
                  <a:off x="249992" y="527417"/>
                  <a:ext cx="2985339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dirty="0"/>
                    <a:t>Not included </a:t>
                  </a:r>
                </a:p>
              </p:txBody>
            </p:sp>
            <p:sp>
              <p:nvSpPr>
                <p:cNvPr id="11" name="ZoneTexte 10">
                  <a:extLst>
                    <a:ext uri="{FF2B5EF4-FFF2-40B4-BE49-F238E27FC236}">
                      <a16:creationId xmlns:a16="http://schemas.microsoft.com/office/drawing/2014/main" id="{663ED4C8-600F-C490-3F82-09B306714052}"/>
                    </a:ext>
                  </a:extLst>
                </p:cNvPr>
                <p:cNvSpPr txBox="1"/>
                <p:nvPr/>
              </p:nvSpPr>
              <p:spPr>
                <a:xfrm rot="16200000">
                  <a:off x="567825" y="572021"/>
                  <a:ext cx="2896131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dirty="0"/>
                    <a:t>Not included </a:t>
                  </a:r>
                </a:p>
              </p:txBody>
            </p:sp>
            <p:sp>
              <p:nvSpPr>
                <p:cNvPr id="12" name="ZoneTexte 11">
                  <a:extLst>
                    <a:ext uri="{FF2B5EF4-FFF2-40B4-BE49-F238E27FC236}">
                      <a16:creationId xmlns:a16="http://schemas.microsoft.com/office/drawing/2014/main" id="{5B28D7D0-1686-7BB1-E959-CF90FE9BDEF4}"/>
                    </a:ext>
                  </a:extLst>
                </p:cNvPr>
                <p:cNvSpPr txBox="1"/>
                <p:nvPr/>
              </p:nvSpPr>
              <p:spPr>
                <a:xfrm rot="16200000">
                  <a:off x="1584343" y="1337600"/>
                  <a:ext cx="1364974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dirty="0"/>
                    <a:t>LPS 1 16/10 </a:t>
                  </a:r>
                </a:p>
              </p:txBody>
            </p:sp>
            <p:sp>
              <p:nvSpPr>
                <p:cNvPr id="13" name="ZoneTexte 12">
                  <a:extLst>
                    <a:ext uri="{FF2B5EF4-FFF2-40B4-BE49-F238E27FC236}">
                      <a16:creationId xmlns:a16="http://schemas.microsoft.com/office/drawing/2014/main" id="{E7447F15-DF17-6CBA-60F7-88CF36D17E97}"/>
                    </a:ext>
                  </a:extLst>
                </p:cNvPr>
                <p:cNvSpPr txBox="1"/>
                <p:nvPr/>
              </p:nvSpPr>
              <p:spPr>
                <a:xfrm rot="16200000">
                  <a:off x="1852533" y="1337600"/>
                  <a:ext cx="1364974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dirty="0"/>
                    <a:t>LPS 2 16/10 </a:t>
                  </a:r>
                </a:p>
              </p:txBody>
            </p:sp>
            <p:sp>
              <p:nvSpPr>
                <p:cNvPr id="14" name="ZoneTexte 13">
                  <a:extLst>
                    <a:ext uri="{FF2B5EF4-FFF2-40B4-BE49-F238E27FC236}">
                      <a16:creationId xmlns:a16="http://schemas.microsoft.com/office/drawing/2014/main" id="{613D0AE1-81E0-5B83-A6C1-0C8D99153259}"/>
                    </a:ext>
                  </a:extLst>
                </p:cNvPr>
                <p:cNvSpPr txBox="1"/>
                <p:nvPr/>
              </p:nvSpPr>
              <p:spPr>
                <a:xfrm rot="16200000">
                  <a:off x="1393115" y="622204"/>
                  <a:ext cx="2795767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dirty="0"/>
                    <a:t>Not included </a:t>
                  </a:r>
                </a:p>
              </p:txBody>
            </p:sp>
            <p:sp>
              <p:nvSpPr>
                <p:cNvPr id="15" name="ZoneTexte 14">
                  <a:extLst>
                    <a:ext uri="{FF2B5EF4-FFF2-40B4-BE49-F238E27FC236}">
                      <a16:creationId xmlns:a16="http://schemas.microsoft.com/office/drawing/2014/main" id="{A8CF09F0-B149-2C8F-934C-DDAD6524F184}"/>
                    </a:ext>
                  </a:extLst>
                </p:cNvPr>
                <p:cNvSpPr txBox="1"/>
                <p:nvPr/>
              </p:nvSpPr>
              <p:spPr>
                <a:xfrm rot="16200000">
                  <a:off x="1972477" y="945587"/>
                  <a:ext cx="2149001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dirty="0"/>
                    <a:t>HSJ633 3-2H 16/10</a:t>
                  </a:r>
                </a:p>
              </p:txBody>
            </p:sp>
            <p:sp>
              <p:nvSpPr>
                <p:cNvPr id="16" name="ZoneTexte 15">
                  <a:extLst>
                    <a:ext uri="{FF2B5EF4-FFF2-40B4-BE49-F238E27FC236}">
                      <a16:creationId xmlns:a16="http://schemas.microsoft.com/office/drawing/2014/main" id="{28163057-C816-A982-42AB-FE28BAA9C554}"/>
                    </a:ext>
                  </a:extLst>
                </p:cNvPr>
                <p:cNvSpPr txBox="1"/>
                <p:nvPr/>
              </p:nvSpPr>
              <p:spPr>
                <a:xfrm rot="16200000">
                  <a:off x="2556400" y="1023647"/>
                  <a:ext cx="1992879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dirty="0"/>
                    <a:t>HSJ633 1-2H 16/10</a:t>
                  </a:r>
                </a:p>
              </p:txBody>
            </p:sp>
            <p:sp>
              <p:nvSpPr>
                <p:cNvPr id="17" name="ZoneTexte 16">
                  <a:extLst>
                    <a:ext uri="{FF2B5EF4-FFF2-40B4-BE49-F238E27FC236}">
                      <a16:creationId xmlns:a16="http://schemas.microsoft.com/office/drawing/2014/main" id="{6EEA822E-C4DE-D56A-E63B-9370FDF10BD4}"/>
                    </a:ext>
                  </a:extLst>
                </p:cNvPr>
                <p:cNvSpPr txBox="1"/>
                <p:nvPr/>
              </p:nvSpPr>
              <p:spPr>
                <a:xfrm rot="16200000">
                  <a:off x="2308878" y="527416"/>
                  <a:ext cx="2985341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dirty="0"/>
                    <a:t>Not included  </a:t>
                  </a:r>
                </a:p>
              </p:txBody>
            </p:sp>
            <p:sp>
              <p:nvSpPr>
                <p:cNvPr id="18" name="ZoneTexte 17">
                  <a:extLst>
                    <a:ext uri="{FF2B5EF4-FFF2-40B4-BE49-F238E27FC236}">
                      <a16:creationId xmlns:a16="http://schemas.microsoft.com/office/drawing/2014/main" id="{44A7F2EE-164C-64A5-4228-CBF1C468AA17}"/>
                    </a:ext>
                  </a:extLst>
                </p:cNvPr>
                <p:cNvSpPr txBox="1"/>
                <p:nvPr/>
              </p:nvSpPr>
              <p:spPr>
                <a:xfrm rot="16200000">
                  <a:off x="2606505" y="572021"/>
                  <a:ext cx="289613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dirty="0"/>
                    <a:t>Not included </a:t>
                  </a:r>
                </a:p>
              </p:txBody>
            </p:sp>
            <p:sp>
              <p:nvSpPr>
                <p:cNvPr id="19" name="ZoneTexte 18">
                  <a:extLst>
                    <a:ext uri="{FF2B5EF4-FFF2-40B4-BE49-F238E27FC236}">
                      <a16:creationId xmlns:a16="http://schemas.microsoft.com/office/drawing/2014/main" id="{E204BA0C-6FE1-1F20-170C-4551F6BF2DAC}"/>
                    </a:ext>
                  </a:extLst>
                </p:cNvPr>
                <p:cNvSpPr txBox="1"/>
                <p:nvPr/>
              </p:nvSpPr>
              <p:spPr>
                <a:xfrm rot="16200000">
                  <a:off x="2597478" y="298817"/>
                  <a:ext cx="3442538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dirty="0"/>
                    <a:t>Not included </a:t>
                  </a:r>
                </a:p>
              </p:txBody>
            </p:sp>
          </p:grpSp>
          <p:sp>
            <p:nvSpPr>
              <p:cNvPr id="4" name="ZoneTexte 3">
                <a:extLst>
                  <a:ext uri="{FF2B5EF4-FFF2-40B4-BE49-F238E27FC236}">
                    <a16:creationId xmlns:a16="http://schemas.microsoft.com/office/drawing/2014/main" id="{601AE4DA-702A-8D25-230A-ADE9D4778038}"/>
                  </a:ext>
                </a:extLst>
              </p:cNvPr>
              <p:cNvSpPr txBox="1"/>
              <p:nvPr/>
            </p:nvSpPr>
            <p:spPr>
              <a:xfrm rot="16200000">
                <a:off x="411262" y="912132"/>
                <a:ext cx="21490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dirty="0"/>
                  <a:t>SHAM 2 16/10 </a:t>
                </a:r>
              </a:p>
            </p:txBody>
          </p:sp>
        </p:grpSp>
      </p:grpSp>
      <p:pic>
        <p:nvPicPr>
          <p:cNvPr id="60" name="Image 59">
            <a:extLst>
              <a:ext uri="{FF2B5EF4-FFF2-40B4-BE49-F238E27FC236}">
                <a16:creationId xmlns:a16="http://schemas.microsoft.com/office/drawing/2014/main" id="{1CB86118-ED69-1A73-63D0-55B9D53FF54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9237" t="17927" r="28537" b="61830"/>
          <a:stretch/>
        </p:blipFill>
        <p:spPr>
          <a:xfrm>
            <a:off x="1358023" y="2134640"/>
            <a:ext cx="3610086" cy="1219351"/>
          </a:xfrm>
          <a:prstGeom prst="rect">
            <a:avLst/>
          </a:prstGeom>
        </p:spPr>
      </p:pic>
      <p:pic>
        <p:nvPicPr>
          <p:cNvPr id="61" name="Image 60">
            <a:extLst>
              <a:ext uri="{FF2B5EF4-FFF2-40B4-BE49-F238E27FC236}">
                <a16:creationId xmlns:a16="http://schemas.microsoft.com/office/drawing/2014/main" id="{655BEE30-8578-BEA1-37E1-F4CB393A32A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6042" t="39101" r="28571" b="40656"/>
          <a:stretch/>
        </p:blipFill>
        <p:spPr>
          <a:xfrm>
            <a:off x="1291449" y="3528691"/>
            <a:ext cx="3880390" cy="1219351"/>
          </a:xfrm>
          <a:prstGeom prst="rect">
            <a:avLst/>
          </a:prstGeom>
        </p:spPr>
      </p:pic>
      <p:pic>
        <p:nvPicPr>
          <p:cNvPr id="20" name="Image 19">
            <a:extLst>
              <a:ext uri="{FF2B5EF4-FFF2-40B4-BE49-F238E27FC236}">
                <a16:creationId xmlns:a16="http://schemas.microsoft.com/office/drawing/2014/main" id="{61437272-E35B-7437-1E6B-3AD2015B350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9590" t="22560" r="27020" b="54458"/>
          <a:stretch/>
        </p:blipFill>
        <p:spPr>
          <a:xfrm>
            <a:off x="8067074" y="2203798"/>
            <a:ext cx="3709690" cy="1384368"/>
          </a:xfrm>
          <a:prstGeom prst="rect">
            <a:avLst/>
          </a:prstGeom>
        </p:spPr>
      </p:pic>
      <p:grpSp>
        <p:nvGrpSpPr>
          <p:cNvPr id="9" name="Groupe 8">
            <a:extLst>
              <a:ext uri="{FF2B5EF4-FFF2-40B4-BE49-F238E27FC236}">
                <a16:creationId xmlns:a16="http://schemas.microsoft.com/office/drawing/2014/main" id="{3F11A9E2-B7B9-2065-5B40-6A94D7B215A2}"/>
              </a:ext>
            </a:extLst>
          </p:cNvPr>
          <p:cNvGrpSpPr/>
          <p:nvPr/>
        </p:nvGrpSpPr>
        <p:grpSpPr>
          <a:xfrm>
            <a:off x="4878901" y="1768596"/>
            <a:ext cx="787289" cy="1616297"/>
            <a:chOff x="1487835" y="1659100"/>
            <a:chExt cx="787289" cy="1616297"/>
          </a:xfrm>
        </p:grpSpPr>
        <p:sp>
          <p:nvSpPr>
            <p:cNvPr id="21" name="ZoneTexte 20">
              <a:extLst>
                <a:ext uri="{FF2B5EF4-FFF2-40B4-BE49-F238E27FC236}">
                  <a16:creationId xmlns:a16="http://schemas.microsoft.com/office/drawing/2014/main" id="{E8258269-5CE8-2753-C678-BB827B8363FE}"/>
                </a:ext>
              </a:extLst>
            </p:cNvPr>
            <p:cNvSpPr txBox="1"/>
            <p:nvPr/>
          </p:nvSpPr>
          <p:spPr>
            <a:xfrm>
              <a:off x="1546254" y="2615411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75</a:t>
              </a:r>
            </a:p>
          </p:txBody>
        </p:sp>
        <p:sp>
          <p:nvSpPr>
            <p:cNvPr id="22" name="ZoneTexte 21">
              <a:extLst>
                <a:ext uri="{FF2B5EF4-FFF2-40B4-BE49-F238E27FC236}">
                  <a16:creationId xmlns:a16="http://schemas.microsoft.com/office/drawing/2014/main" id="{060337D1-F88F-BB57-7542-CEA41FE0D176}"/>
                </a:ext>
              </a:extLst>
            </p:cNvPr>
            <p:cNvSpPr txBox="1"/>
            <p:nvPr/>
          </p:nvSpPr>
          <p:spPr>
            <a:xfrm>
              <a:off x="1535103" y="2998398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50</a:t>
              </a:r>
            </a:p>
          </p:txBody>
        </p:sp>
        <p:sp>
          <p:nvSpPr>
            <p:cNvPr id="30" name="ZoneTexte 29">
              <a:extLst>
                <a:ext uri="{FF2B5EF4-FFF2-40B4-BE49-F238E27FC236}">
                  <a16:creationId xmlns:a16="http://schemas.microsoft.com/office/drawing/2014/main" id="{14B1EF44-CB44-B6E2-3E48-E8E6240D1402}"/>
                </a:ext>
              </a:extLst>
            </p:cNvPr>
            <p:cNvSpPr txBox="1"/>
            <p:nvPr/>
          </p:nvSpPr>
          <p:spPr>
            <a:xfrm>
              <a:off x="1487835" y="2147805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150</a:t>
              </a:r>
            </a:p>
          </p:txBody>
        </p:sp>
        <p:sp>
          <p:nvSpPr>
            <p:cNvPr id="31" name="ZoneTexte 30">
              <a:extLst>
                <a:ext uri="{FF2B5EF4-FFF2-40B4-BE49-F238E27FC236}">
                  <a16:creationId xmlns:a16="http://schemas.microsoft.com/office/drawing/2014/main" id="{BB657997-EB75-CACC-5EF5-0FA74BD3F158}"/>
                </a:ext>
              </a:extLst>
            </p:cNvPr>
            <p:cNvSpPr txBox="1"/>
            <p:nvPr/>
          </p:nvSpPr>
          <p:spPr>
            <a:xfrm>
              <a:off x="1487835" y="2376528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100</a:t>
              </a:r>
            </a:p>
          </p:txBody>
        </p:sp>
        <p:sp>
          <p:nvSpPr>
            <p:cNvPr id="32" name="ZoneTexte 31">
              <a:extLst>
                <a:ext uri="{FF2B5EF4-FFF2-40B4-BE49-F238E27FC236}">
                  <a16:creationId xmlns:a16="http://schemas.microsoft.com/office/drawing/2014/main" id="{D52D530A-E37C-132B-0CF3-3E97A3AEE45E}"/>
                </a:ext>
              </a:extLst>
            </p:cNvPr>
            <p:cNvSpPr txBox="1"/>
            <p:nvPr/>
          </p:nvSpPr>
          <p:spPr>
            <a:xfrm>
              <a:off x="1503915" y="2000932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250</a:t>
              </a:r>
            </a:p>
          </p:txBody>
        </p:sp>
        <p:sp>
          <p:nvSpPr>
            <p:cNvPr id="33" name="ZoneTexte 32">
              <a:extLst>
                <a:ext uri="{FF2B5EF4-FFF2-40B4-BE49-F238E27FC236}">
                  <a16:creationId xmlns:a16="http://schemas.microsoft.com/office/drawing/2014/main" id="{D9CECCD8-808A-DD93-17F8-E840A3656C52}"/>
                </a:ext>
              </a:extLst>
            </p:cNvPr>
            <p:cNvSpPr txBox="1"/>
            <p:nvPr/>
          </p:nvSpPr>
          <p:spPr>
            <a:xfrm>
              <a:off x="1487835" y="1659100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err="1"/>
                <a:t>kDa</a:t>
              </a:r>
              <a:endParaRPr lang="en-CA" sz="1200" dirty="0"/>
            </a:p>
          </p:txBody>
        </p:sp>
      </p:grpSp>
      <p:grpSp>
        <p:nvGrpSpPr>
          <p:cNvPr id="42" name="Groupe 41">
            <a:extLst>
              <a:ext uri="{FF2B5EF4-FFF2-40B4-BE49-F238E27FC236}">
                <a16:creationId xmlns:a16="http://schemas.microsoft.com/office/drawing/2014/main" id="{F6210B83-59F2-4954-C26B-DCD66912F927}"/>
              </a:ext>
            </a:extLst>
          </p:cNvPr>
          <p:cNvGrpSpPr/>
          <p:nvPr/>
        </p:nvGrpSpPr>
        <p:grpSpPr>
          <a:xfrm>
            <a:off x="11667281" y="1880033"/>
            <a:ext cx="787289" cy="1616297"/>
            <a:chOff x="1487835" y="1659100"/>
            <a:chExt cx="787289" cy="1616297"/>
          </a:xfrm>
        </p:grpSpPr>
        <p:sp>
          <p:nvSpPr>
            <p:cNvPr id="43" name="ZoneTexte 42">
              <a:extLst>
                <a:ext uri="{FF2B5EF4-FFF2-40B4-BE49-F238E27FC236}">
                  <a16:creationId xmlns:a16="http://schemas.microsoft.com/office/drawing/2014/main" id="{0D847F9C-3966-604F-B8BD-40E2208AAB65}"/>
                </a:ext>
              </a:extLst>
            </p:cNvPr>
            <p:cNvSpPr txBox="1"/>
            <p:nvPr/>
          </p:nvSpPr>
          <p:spPr>
            <a:xfrm>
              <a:off x="1546254" y="2615411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75</a:t>
              </a:r>
            </a:p>
          </p:txBody>
        </p:sp>
        <p:sp>
          <p:nvSpPr>
            <p:cNvPr id="44" name="ZoneTexte 43">
              <a:extLst>
                <a:ext uri="{FF2B5EF4-FFF2-40B4-BE49-F238E27FC236}">
                  <a16:creationId xmlns:a16="http://schemas.microsoft.com/office/drawing/2014/main" id="{2DBDB376-5D68-A9A5-16C5-55FB1410FDA6}"/>
                </a:ext>
              </a:extLst>
            </p:cNvPr>
            <p:cNvSpPr txBox="1"/>
            <p:nvPr/>
          </p:nvSpPr>
          <p:spPr>
            <a:xfrm>
              <a:off x="1535103" y="2998398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50</a:t>
              </a:r>
            </a:p>
          </p:txBody>
        </p:sp>
        <p:sp>
          <p:nvSpPr>
            <p:cNvPr id="45" name="ZoneTexte 44">
              <a:extLst>
                <a:ext uri="{FF2B5EF4-FFF2-40B4-BE49-F238E27FC236}">
                  <a16:creationId xmlns:a16="http://schemas.microsoft.com/office/drawing/2014/main" id="{5EA7938B-B7B0-10F4-35F2-0E5C1AFA0DD6}"/>
                </a:ext>
              </a:extLst>
            </p:cNvPr>
            <p:cNvSpPr txBox="1"/>
            <p:nvPr/>
          </p:nvSpPr>
          <p:spPr>
            <a:xfrm>
              <a:off x="1487835" y="2147805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150</a:t>
              </a:r>
            </a:p>
          </p:txBody>
        </p:sp>
        <p:sp>
          <p:nvSpPr>
            <p:cNvPr id="59" name="ZoneTexte 58">
              <a:extLst>
                <a:ext uri="{FF2B5EF4-FFF2-40B4-BE49-F238E27FC236}">
                  <a16:creationId xmlns:a16="http://schemas.microsoft.com/office/drawing/2014/main" id="{1B64CAB9-8154-740E-41FD-8BBB89C20636}"/>
                </a:ext>
              </a:extLst>
            </p:cNvPr>
            <p:cNvSpPr txBox="1"/>
            <p:nvPr/>
          </p:nvSpPr>
          <p:spPr>
            <a:xfrm>
              <a:off x="1487835" y="2376528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100</a:t>
              </a:r>
            </a:p>
          </p:txBody>
        </p:sp>
        <p:sp>
          <p:nvSpPr>
            <p:cNvPr id="62" name="ZoneTexte 61">
              <a:extLst>
                <a:ext uri="{FF2B5EF4-FFF2-40B4-BE49-F238E27FC236}">
                  <a16:creationId xmlns:a16="http://schemas.microsoft.com/office/drawing/2014/main" id="{190D1E1D-CD6B-BB1A-9271-25E11659886F}"/>
                </a:ext>
              </a:extLst>
            </p:cNvPr>
            <p:cNvSpPr txBox="1"/>
            <p:nvPr/>
          </p:nvSpPr>
          <p:spPr>
            <a:xfrm>
              <a:off x="1503915" y="2000932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250</a:t>
              </a:r>
            </a:p>
          </p:txBody>
        </p:sp>
        <p:sp>
          <p:nvSpPr>
            <p:cNvPr id="63" name="ZoneTexte 62">
              <a:extLst>
                <a:ext uri="{FF2B5EF4-FFF2-40B4-BE49-F238E27FC236}">
                  <a16:creationId xmlns:a16="http://schemas.microsoft.com/office/drawing/2014/main" id="{47597C48-1134-86BE-E856-97B4E4C9DAE6}"/>
                </a:ext>
              </a:extLst>
            </p:cNvPr>
            <p:cNvSpPr txBox="1"/>
            <p:nvPr/>
          </p:nvSpPr>
          <p:spPr>
            <a:xfrm>
              <a:off x="1487835" y="1659100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err="1"/>
                <a:t>kDa</a:t>
              </a:r>
              <a:endParaRPr lang="en-CA" sz="1200" dirty="0"/>
            </a:p>
          </p:txBody>
        </p:sp>
      </p:grpSp>
      <p:grpSp>
        <p:nvGrpSpPr>
          <p:cNvPr id="24" name="Groupe 23">
            <a:extLst>
              <a:ext uri="{FF2B5EF4-FFF2-40B4-BE49-F238E27FC236}">
                <a16:creationId xmlns:a16="http://schemas.microsoft.com/office/drawing/2014/main" id="{D80D63ED-BC69-6C33-4704-CEDB825BBFB2}"/>
              </a:ext>
            </a:extLst>
          </p:cNvPr>
          <p:cNvGrpSpPr/>
          <p:nvPr/>
        </p:nvGrpSpPr>
        <p:grpSpPr>
          <a:xfrm>
            <a:off x="8050994" y="-1197232"/>
            <a:ext cx="3202317" cy="3442539"/>
            <a:chOff x="1301096" y="-1271240"/>
            <a:chExt cx="3202317" cy="3442539"/>
          </a:xfrm>
        </p:grpSpPr>
        <p:sp>
          <p:nvSpPr>
            <p:cNvPr id="34" name="ZoneTexte 33">
              <a:extLst>
                <a:ext uri="{FF2B5EF4-FFF2-40B4-BE49-F238E27FC236}">
                  <a16:creationId xmlns:a16="http://schemas.microsoft.com/office/drawing/2014/main" id="{30D5DFBC-9186-71C7-7E45-16313AFDD77B}"/>
                </a:ext>
              </a:extLst>
            </p:cNvPr>
            <p:cNvSpPr txBox="1"/>
            <p:nvPr/>
          </p:nvSpPr>
          <p:spPr>
            <a:xfrm rot="16200000">
              <a:off x="2236181" y="912132"/>
              <a:ext cx="214900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/>
                <a:t>HSJ633 2-2H 16/10</a:t>
              </a:r>
            </a:p>
          </p:txBody>
        </p:sp>
        <p:grpSp>
          <p:nvGrpSpPr>
            <p:cNvPr id="35" name="Groupe 34">
              <a:extLst>
                <a:ext uri="{FF2B5EF4-FFF2-40B4-BE49-F238E27FC236}">
                  <a16:creationId xmlns:a16="http://schemas.microsoft.com/office/drawing/2014/main" id="{7ADD45E6-F299-61E3-8111-A73C6BB4BA6A}"/>
                </a:ext>
              </a:extLst>
            </p:cNvPr>
            <p:cNvGrpSpPr/>
            <p:nvPr/>
          </p:nvGrpSpPr>
          <p:grpSpPr>
            <a:xfrm>
              <a:off x="1301096" y="-1271240"/>
              <a:ext cx="3202317" cy="3442539"/>
              <a:chOff x="1301096" y="-1271240"/>
              <a:chExt cx="3202317" cy="3442539"/>
            </a:xfrm>
          </p:grpSpPr>
          <p:grpSp>
            <p:nvGrpSpPr>
              <p:cNvPr id="36" name="Groupe 35">
                <a:extLst>
                  <a:ext uri="{FF2B5EF4-FFF2-40B4-BE49-F238E27FC236}">
                    <a16:creationId xmlns:a16="http://schemas.microsoft.com/office/drawing/2014/main" id="{B1E32F05-B53B-0450-739B-EF0B176257DD}"/>
                  </a:ext>
                </a:extLst>
              </p:cNvPr>
              <p:cNvGrpSpPr/>
              <p:nvPr/>
            </p:nvGrpSpPr>
            <p:grpSpPr>
              <a:xfrm>
                <a:off x="1557996" y="-1271240"/>
                <a:ext cx="2945417" cy="3442539"/>
                <a:chOff x="1557996" y="-1237786"/>
                <a:chExt cx="2945417" cy="3442539"/>
              </a:xfrm>
            </p:grpSpPr>
            <p:sp>
              <p:nvSpPr>
                <p:cNvPr id="38" name="ZoneTexte 37">
                  <a:extLst>
                    <a:ext uri="{FF2B5EF4-FFF2-40B4-BE49-F238E27FC236}">
                      <a16:creationId xmlns:a16="http://schemas.microsoft.com/office/drawing/2014/main" id="{4A00CE72-92AB-B0BC-FB75-AAE7BEF46525}"/>
                    </a:ext>
                  </a:extLst>
                </p:cNvPr>
                <p:cNvSpPr txBox="1"/>
                <p:nvPr/>
              </p:nvSpPr>
              <p:spPr>
                <a:xfrm rot="16200000">
                  <a:off x="249992" y="527417"/>
                  <a:ext cx="2985339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dirty="0"/>
                    <a:t>Not included </a:t>
                  </a:r>
                </a:p>
              </p:txBody>
            </p:sp>
            <p:sp>
              <p:nvSpPr>
                <p:cNvPr id="39" name="ZoneTexte 38">
                  <a:extLst>
                    <a:ext uri="{FF2B5EF4-FFF2-40B4-BE49-F238E27FC236}">
                      <a16:creationId xmlns:a16="http://schemas.microsoft.com/office/drawing/2014/main" id="{D5D18D47-D7DE-AA30-211A-82C7066CAF78}"/>
                    </a:ext>
                  </a:extLst>
                </p:cNvPr>
                <p:cNvSpPr txBox="1"/>
                <p:nvPr/>
              </p:nvSpPr>
              <p:spPr>
                <a:xfrm rot="16200000">
                  <a:off x="567825" y="572021"/>
                  <a:ext cx="2896131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dirty="0"/>
                    <a:t>Not included </a:t>
                  </a:r>
                </a:p>
              </p:txBody>
            </p:sp>
            <p:sp>
              <p:nvSpPr>
                <p:cNvPr id="40" name="ZoneTexte 39">
                  <a:extLst>
                    <a:ext uri="{FF2B5EF4-FFF2-40B4-BE49-F238E27FC236}">
                      <a16:creationId xmlns:a16="http://schemas.microsoft.com/office/drawing/2014/main" id="{612FFD1F-0AE5-6EB6-1B78-769CE96CA5D0}"/>
                    </a:ext>
                  </a:extLst>
                </p:cNvPr>
                <p:cNvSpPr txBox="1"/>
                <p:nvPr/>
              </p:nvSpPr>
              <p:spPr>
                <a:xfrm rot="16200000">
                  <a:off x="1584343" y="1337600"/>
                  <a:ext cx="1364974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dirty="0"/>
                    <a:t>LPS 1 16/10 </a:t>
                  </a:r>
                </a:p>
              </p:txBody>
            </p:sp>
            <p:sp>
              <p:nvSpPr>
                <p:cNvPr id="41" name="ZoneTexte 40">
                  <a:extLst>
                    <a:ext uri="{FF2B5EF4-FFF2-40B4-BE49-F238E27FC236}">
                      <a16:creationId xmlns:a16="http://schemas.microsoft.com/office/drawing/2014/main" id="{53053819-8A39-D671-4F77-3B11893A7D22}"/>
                    </a:ext>
                  </a:extLst>
                </p:cNvPr>
                <p:cNvSpPr txBox="1"/>
                <p:nvPr/>
              </p:nvSpPr>
              <p:spPr>
                <a:xfrm rot="16200000">
                  <a:off x="1852533" y="1337600"/>
                  <a:ext cx="1364974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dirty="0"/>
                    <a:t>LPS 2 16/10 </a:t>
                  </a:r>
                </a:p>
              </p:txBody>
            </p:sp>
            <p:sp>
              <p:nvSpPr>
                <p:cNvPr id="64" name="ZoneTexte 63">
                  <a:extLst>
                    <a:ext uri="{FF2B5EF4-FFF2-40B4-BE49-F238E27FC236}">
                      <a16:creationId xmlns:a16="http://schemas.microsoft.com/office/drawing/2014/main" id="{1AE5C10F-32E5-18A5-EED0-E1F20ACBB8B2}"/>
                    </a:ext>
                  </a:extLst>
                </p:cNvPr>
                <p:cNvSpPr txBox="1"/>
                <p:nvPr/>
              </p:nvSpPr>
              <p:spPr>
                <a:xfrm rot="16200000">
                  <a:off x="1393115" y="622204"/>
                  <a:ext cx="2795767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dirty="0"/>
                    <a:t>Not included </a:t>
                  </a:r>
                </a:p>
              </p:txBody>
            </p:sp>
            <p:sp>
              <p:nvSpPr>
                <p:cNvPr id="65" name="ZoneTexte 64">
                  <a:extLst>
                    <a:ext uri="{FF2B5EF4-FFF2-40B4-BE49-F238E27FC236}">
                      <a16:creationId xmlns:a16="http://schemas.microsoft.com/office/drawing/2014/main" id="{77340529-6FAB-7D1D-9A28-79B79852A4BB}"/>
                    </a:ext>
                  </a:extLst>
                </p:cNvPr>
                <p:cNvSpPr txBox="1"/>
                <p:nvPr/>
              </p:nvSpPr>
              <p:spPr>
                <a:xfrm rot="16200000">
                  <a:off x="1972477" y="945587"/>
                  <a:ext cx="2149001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dirty="0"/>
                    <a:t>HSJ633 3-2H 16/10</a:t>
                  </a:r>
                </a:p>
              </p:txBody>
            </p:sp>
            <p:sp>
              <p:nvSpPr>
                <p:cNvPr id="66" name="ZoneTexte 65">
                  <a:extLst>
                    <a:ext uri="{FF2B5EF4-FFF2-40B4-BE49-F238E27FC236}">
                      <a16:creationId xmlns:a16="http://schemas.microsoft.com/office/drawing/2014/main" id="{8E44DF07-B2F8-74BF-CBF4-94F2DB1E86BE}"/>
                    </a:ext>
                  </a:extLst>
                </p:cNvPr>
                <p:cNvSpPr txBox="1"/>
                <p:nvPr/>
              </p:nvSpPr>
              <p:spPr>
                <a:xfrm rot="16200000">
                  <a:off x="2556400" y="1023647"/>
                  <a:ext cx="1992879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dirty="0"/>
                    <a:t>HSJ633 1-2H 16/10</a:t>
                  </a:r>
                </a:p>
              </p:txBody>
            </p:sp>
            <p:sp>
              <p:nvSpPr>
                <p:cNvPr id="67" name="ZoneTexte 66">
                  <a:extLst>
                    <a:ext uri="{FF2B5EF4-FFF2-40B4-BE49-F238E27FC236}">
                      <a16:creationId xmlns:a16="http://schemas.microsoft.com/office/drawing/2014/main" id="{C6322190-E076-7930-DFCA-D110E8B0B9B9}"/>
                    </a:ext>
                  </a:extLst>
                </p:cNvPr>
                <p:cNvSpPr txBox="1"/>
                <p:nvPr/>
              </p:nvSpPr>
              <p:spPr>
                <a:xfrm rot="16200000">
                  <a:off x="2308878" y="527416"/>
                  <a:ext cx="2985341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dirty="0"/>
                    <a:t>Not included  </a:t>
                  </a:r>
                </a:p>
              </p:txBody>
            </p:sp>
            <p:sp>
              <p:nvSpPr>
                <p:cNvPr id="68" name="ZoneTexte 67">
                  <a:extLst>
                    <a:ext uri="{FF2B5EF4-FFF2-40B4-BE49-F238E27FC236}">
                      <a16:creationId xmlns:a16="http://schemas.microsoft.com/office/drawing/2014/main" id="{61875CC4-F80D-BC3F-85F8-BAF2D626E0BA}"/>
                    </a:ext>
                  </a:extLst>
                </p:cNvPr>
                <p:cNvSpPr txBox="1"/>
                <p:nvPr/>
              </p:nvSpPr>
              <p:spPr>
                <a:xfrm rot="16200000">
                  <a:off x="2606505" y="572021"/>
                  <a:ext cx="289613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dirty="0"/>
                    <a:t>Not included </a:t>
                  </a:r>
                </a:p>
              </p:txBody>
            </p:sp>
            <p:sp>
              <p:nvSpPr>
                <p:cNvPr id="69" name="ZoneTexte 68">
                  <a:extLst>
                    <a:ext uri="{FF2B5EF4-FFF2-40B4-BE49-F238E27FC236}">
                      <a16:creationId xmlns:a16="http://schemas.microsoft.com/office/drawing/2014/main" id="{A0AED540-CA8D-66DF-36FE-91FDAEBBED7F}"/>
                    </a:ext>
                  </a:extLst>
                </p:cNvPr>
                <p:cNvSpPr txBox="1"/>
                <p:nvPr/>
              </p:nvSpPr>
              <p:spPr>
                <a:xfrm rot="16200000">
                  <a:off x="2597478" y="298817"/>
                  <a:ext cx="3442538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dirty="0"/>
                    <a:t>Not included </a:t>
                  </a:r>
                </a:p>
              </p:txBody>
            </p:sp>
          </p:grpSp>
          <p:sp>
            <p:nvSpPr>
              <p:cNvPr id="37" name="ZoneTexte 36">
                <a:extLst>
                  <a:ext uri="{FF2B5EF4-FFF2-40B4-BE49-F238E27FC236}">
                    <a16:creationId xmlns:a16="http://schemas.microsoft.com/office/drawing/2014/main" id="{D37D4539-2BAB-0A12-7DF2-5916F914EF71}"/>
                  </a:ext>
                </a:extLst>
              </p:cNvPr>
              <p:cNvSpPr txBox="1"/>
              <p:nvPr/>
            </p:nvSpPr>
            <p:spPr>
              <a:xfrm rot="16200000">
                <a:off x="411262" y="912132"/>
                <a:ext cx="21490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dirty="0"/>
                  <a:t>SHAM 2 16/10 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33522940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6</TotalTime>
  <Words>151</Words>
  <Application>Microsoft Macintosh PowerPoint</Application>
  <PresentationFormat>Grand écran</PresentationFormat>
  <Paragraphs>88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hème Office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rance Côté</dc:creator>
  <cp:lastModifiedBy>France Côté</cp:lastModifiedBy>
  <cp:revision>13</cp:revision>
  <dcterms:created xsi:type="dcterms:W3CDTF">2023-10-06T14:20:44Z</dcterms:created>
  <dcterms:modified xsi:type="dcterms:W3CDTF">2024-11-08T16:47:18Z</dcterms:modified>
</cp:coreProperties>
</file>